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Ex1.xml" ContentType="application/vnd.ms-office.chartex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96" r:id="rId2"/>
    <p:sldId id="298" r:id="rId3"/>
    <p:sldId id="292" r:id="rId4"/>
    <p:sldId id="297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2" autoAdjust="0"/>
    <p:restoredTop sz="92352" autoAdjust="0"/>
  </p:normalViewPr>
  <p:slideViewPr>
    <p:cSldViewPr snapToGrid="0">
      <p:cViewPr varScale="1">
        <p:scale>
          <a:sx n="83" d="100"/>
          <a:sy n="83" d="100"/>
        </p:scale>
        <p:origin x="45" y="2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https://d.docs.live.net/ca837e8183b728ce/&#12487;&#12473;&#12463;&#12488;&#12483;&#12503;/&#12463;&#12522;&#12503;&#12488;&#12467;&#12483;&#12463;&#12473;/&#24180;&#40802;&#35519;&#31680;&#30330;&#30151;&#29575;/&#24180;&#40802;&#32676;&#21029;AAR/&#24180;&#40802;&#32676;AAR&#12414;&#12392;&#12417;.xlsx" TargetMode="External"/></Relationships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strDim type="cat">
        <cx:f>[年齢群AARまとめ.xlsx]Sheet2!$O$6:$O$61</cx:f>
        <cx:lvl ptCount="56">
          <cx:pt idx="0">0–9</cx:pt>
          <cx:pt idx="1">0–9</cx:pt>
          <cx:pt idx="2">0–9</cx:pt>
          <cx:pt idx="3">0–9</cx:pt>
          <cx:pt idx="4">0–9</cx:pt>
          <cx:pt idx="5">0–9</cx:pt>
          <cx:pt idx="6">0–9</cx:pt>
          <cx:pt idx="7">10–19</cx:pt>
          <cx:pt idx="8">10–19</cx:pt>
          <cx:pt idx="9">10–19</cx:pt>
          <cx:pt idx="10">10–19</cx:pt>
          <cx:pt idx="11">10–19</cx:pt>
          <cx:pt idx="12">10–19</cx:pt>
          <cx:pt idx="13">10–19</cx:pt>
          <cx:pt idx="14">20–29</cx:pt>
          <cx:pt idx="15">20–29</cx:pt>
          <cx:pt idx="16">20–29</cx:pt>
          <cx:pt idx="17">20–29</cx:pt>
          <cx:pt idx="18">20–29</cx:pt>
          <cx:pt idx="19">20–29</cx:pt>
          <cx:pt idx="20">20–29</cx:pt>
          <cx:pt idx="21">30–39</cx:pt>
          <cx:pt idx="22">30–39</cx:pt>
          <cx:pt idx="23">30–39</cx:pt>
          <cx:pt idx="24">30–39</cx:pt>
          <cx:pt idx="25">30–39</cx:pt>
          <cx:pt idx="26">30–39</cx:pt>
          <cx:pt idx="27">30–39</cx:pt>
          <cx:pt idx="28">40–49</cx:pt>
          <cx:pt idx="29">40–49</cx:pt>
          <cx:pt idx="30">40–49</cx:pt>
          <cx:pt idx="31">40–49</cx:pt>
          <cx:pt idx="32">40–49</cx:pt>
          <cx:pt idx="33">40–49</cx:pt>
          <cx:pt idx="34">40–49</cx:pt>
          <cx:pt idx="35">50–59</cx:pt>
          <cx:pt idx="36">50–59</cx:pt>
          <cx:pt idx="37">50–59</cx:pt>
          <cx:pt idx="38">50–59</cx:pt>
          <cx:pt idx="39">50–59</cx:pt>
          <cx:pt idx="40">50–59</cx:pt>
          <cx:pt idx="41">50–59</cx:pt>
          <cx:pt idx="42">60–69</cx:pt>
          <cx:pt idx="43">60–69</cx:pt>
          <cx:pt idx="44">60–69</cx:pt>
          <cx:pt idx="45">60–69</cx:pt>
          <cx:pt idx="46">60–69</cx:pt>
          <cx:pt idx="47">60–69</cx:pt>
          <cx:pt idx="48">60–69</cx:pt>
          <cx:pt idx="49">≥70</cx:pt>
          <cx:pt idx="50">≥70</cx:pt>
          <cx:pt idx="51">≥70</cx:pt>
          <cx:pt idx="52">≥70</cx:pt>
          <cx:pt idx="53">≥70</cx:pt>
          <cx:pt idx="54">≥70</cx:pt>
          <cx:pt idx="55">≥70</cx:pt>
        </cx:lvl>
      </cx:strDim>
      <cx:numDim type="val">
        <cx:f>[年齢群AARまとめ.xlsx]Sheet2!$P$6:$P$61</cx:f>
        <cx:lvl ptCount="56" formatCode="G/標準">
          <cx:pt idx="0">0.01</cx:pt>
          <cx:pt idx="1">0</cx:pt>
          <cx:pt idx="2">0.01</cx:pt>
          <cx:pt idx="3">0</cx:pt>
          <cx:pt idx="4">0</cx:pt>
          <cx:pt idx="5">0</cx:pt>
          <cx:pt idx="6">0</cx:pt>
          <cx:pt idx="7">0</cx:pt>
          <cx:pt idx="8">0</cx:pt>
          <cx:pt idx="9">0.0089999999999999993</cx:pt>
          <cx:pt idx="10">0.0089999999999999993</cx:pt>
          <cx:pt idx="11">0</cx:pt>
          <cx:pt idx="12">0.017999999999999999</cx:pt>
          <cx:pt idx="13">0</cx:pt>
          <cx:pt idx="14">0.031</cx:pt>
          <cx:pt idx="15">0.0080000000000000002</cx:pt>
          <cx:pt idx="16">0.032000000000000001</cx:pt>
          <cx:pt idx="17">0.0080000000000000002</cx:pt>
          <cx:pt idx="18">0.0080000000000000002</cx:pt>
          <cx:pt idx="19">0.032000000000000001</cx:pt>
          <cx:pt idx="20">0</cx:pt>
          <cx:pt idx="21">0.125</cx:pt>
          <cx:pt idx="22">0.025999999999999999</cx:pt>
          <cx:pt idx="23">0.02</cx:pt>
          <cx:pt idx="24">0.027</cx:pt>
          <cx:pt idx="25">0.028000000000000001</cx:pt>
          <cx:pt idx="26">0.021000000000000001</cx:pt>
          <cx:pt idx="27">0.042999999999999997</cx:pt>
          <cx:pt idx="28">0.065000000000000002</cx:pt>
          <cx:pt idx="29">0.032000000000000001</cx:pt>
          <cx:pt idx="30">0.036999999999999998</cx:pt>
          <cx:pt idx="31">0.021000000000000001</cx:pt>
          <cx:pt idx="32">0.037999999999999999</cx:pt>
          <cx:pt idx="33">0.070000000000000007</cx:pt>
          <cx:pt idx="34">0.039</cx:pt>
          <cx:pt idx="35">0.025999999999999999</cx:pt>
          <cx:pt idx="36">0.058000000000000003</cx:pt>
          <cx:pt idx="37">0.064000000000000001</cx:pt>
          <cx:pt idx="38">0.081000000000000003</cx:pt>
          <cx:pt idx="39">0.060999999999999999</cx:pt>
          <cx:pt idx="40">0.036999999999999998</cx:pt>
          <cx:pt idx="41">0.052999999999999999</cx:pt>
          <cx:pt idx="42">0.099000000000000005</cx:pt>
          <cx:pt idx="43">0.14599999999999999</cx:pt>
          <cx:pt idx="44">0.13500000000000001</cx:pt>
          <cx:pt idx="45">0.153</cx:pt>
          <cx:pt idx="46">0.13600000000000001</cx:pt>
          <cx:pt idx="47">0.13100000000000001</cx:pt>
          <cx:pt idx="48">0.16400000000000001</cx:pt>
          <cx:pt idx="49">0.33000000000000002</cx:pt>
          <cx:pt idx="50">0.37</cx:pt>
          <cx:pt idx="51">0.34000000000000002</cx:pt>
          <cx:pt idx="52">0.51000000000000001</cx:pt>
          <cx:pt idx="53">0.40999999999999998</cx:pt>
          <cx:pt idx="54">0.38</cx:pt>
          <cx:pt idx="55">0.40999999999999998</cx:pt>
        </cx:lvl>
      </cx:numDim>
    </cx:data>
  </cx:chartData>
  <cx:chart>
    <cx:plotArea>
      <cx:plotAreaRegion>
        <cx:series layoutId="boxWhisker" uniqueId="{1CA455DC-CE32-409B-8EAF-8176918996B5}">
          <cx:spPr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accent2"/>
              </a:solidFill>
            </a:ln>
          </cx:spPr>
          <cx:dataId val="0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1"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/>
                </a:pPr>
                <a:r>
                  <a:rPr lang="en-US" altLang="ja-JP" sz="1800" b="0" i="0" u="none" strike="noStrike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Times New Roman"/>
                    <a:ea typeface="メイリオ"/>
                  </a:rPr>
                  <a:t>10 year age group</a:t>
                </a:r>
                <a:endParaRPr lang="ja-JP" altLang="en-US" sz="1800" b="0" i="0" u="none" strike="noStrike" baseline="0" dirty="0">
                  <a:solidFill>
                    <a:prstClr val="black">
                      <a:lumMod val="65000"/>
                      <a:lumOff val="35000"/>
                    </a:prstClr>
                  </a:solidFill>
                  <a:latin typeface="Times New Roman"/>
                  <a:ea typeface="メイリオ"/>
                </a:endParaRPr>
              </a:p>
            </cx:rich>
          </cx:tx>
        </cx:title>
        <cx:tickLabels/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400" baseline="0"/>
            </a:pPr>
            <a:endParaRPr lang="ja-JP" altLang="en-US" sz="1400" b="0" i="0" u="none" strike="noStrike" baseline="0">
              <a:solidFill>
                <a:prstClr val="black">
                  <a:lumMod val="65000"/>
                  <a:lumOff val="35000"/>
                </a:prstClr>
              </a:solidFill>
              <a:latin typeface="Times New Roman"/>
              <a:ea typeface="メイリオ"/>
            </a:endParaRPr>
          </a:p>
        </cx:txPr>
      </cx:axis>
      <cx:axis id="1">
        <cx:valScaling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/>
                </a:pPr>
                <a:r>
                  <a:rPr lang="en-US" altLang="ja-JP" sz="1800" b="0" i="0" u="none" strike="noStrike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メイリオ"/>
                  </a:rPr>
                  <a:t>Crude incidence rate</a:t>
                </a:r>
                <a:endParaRPr lang="ja-JP" altLang="en-US" sz="1800" b="0" i="0" u="none" strike="noStrike" baseline="0" dirty="0">
                  <a:solidFill>
                    <a:prstClr val="black">
                      <a:lumMod val="65000"/>
                      <a:lumOff val="35000"/>
                    </a:prstClr>
                  </a:solidFill>
                  <a:latin typeface="+mn-lt"/>
                  <a:ea typeface="メイリオ"/>
                </a:endParaRPr>
              </a:p>
            </cx:rich>
          </cx:tx>
        </cx:title>
        <cx:majorGridlines/>
        <cx:tickLabels/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400" baseline="0"/>
            </a:pPr>
            <a:endParaRPr lang="ja-JP" altLang="en-US" sz="1400" b="0" i="0" u="none" strike="noStrike" baseline="0">
              <a:solidFill>
                <a:prstClr val="black">
                  <a:lumMod val="65000"/>
                  <a:lumOff val="35000"/>
                </a:prstClr>
              </a:solidFill>
              <a:latin typeface="Times New Roman"/>
              <a:ea typeface="メイリオ"/>
            </a:endParaRPr>
          </a:p>
        </cx:txPr>
      </cx:axis>
    </cx:plotArea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B4CDE5-7851-4946-AAF6-9C8EAE4237B1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DA4A06-A464-4E57-AAED-D529FC6E51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38449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EDA4A06-A464-4E57-AAED-D529FC6E518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38992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&gt; </a:t>
            </a:r>
            <a:r>
              <a:rPr kumimoji="1" lang="en-US" altLang="ja-JP" dirty="0" err="1"/>
              <a:t>mannwhitney.table</a:t>
            </a:r>
            <a:endParaRPr kumimoji="1" lang="en-US" altLang="ja-JP" dirty="0"/>
          </a:p>
          <a:p>
            <a:r>
              <a:rPr kumimoji="1" lang="en-US" altLang="ja-JP" dirty="0"/>
              <a:t>          </a:t>
            </a:r>
            <a:r>
              <a:rPr kumimoji="1" lang="ja-JP" altLang="en-US" dirty="0"/>
              <a:t>　　　</a:t>
            </a:r>
            <a:r>
              <a:rPr kumimoji="1" lang="en-US" altLang="ja-JP" dirty="0"/>
              <a:t> </a:t>
            </a:r>
            <a:r>
              <a:rPr kumimoji="1" lang="ja-JP" altLang="en-US" dirty="0"/>
              <a:t>最小   　</a:t>
            </a:r>
            <a:r>
              <a:rPr kumimoji="1" lang="en-US" altLang="ja-JP" dirty="0"/>
              <a:t>25% </a:t>
            </a:r>
            <a:r>
              <a:rPr kumimoji="1" lang="ja-JP" altLang="en-US" dirty="0"/>
              <a:t>　　　メディアン   　</a:t>
            </a:r>
            <a:r>
              <a:rPr kumimoji="1" lang="en-US" altLang="ja-JP" dirty="0"/>
              <a:t>75% </a:t>
            </a:r>
            <a:r>
              <a:rPr kumimoji="1" lang="ja-JP" altLang="en-US" dirty="0"/>
              <a:t>　　　最大   　　　 </a:t>
            </a:r>
            <a:r>
              <a:rPr kumimoji="1" lang="en-US" altLang="ja-JP" dirty="0"/>
              <a:t>P</a:t>
            </a:r>
            <a:r>
              <a:rPr kumimoji="1" lang="ja-JP" altLang="en-US" dirty="0"/>
              <a:t>値</a:t>
            </a:r>
          </a:p>
          <a:p>
            <a:r>
              <a:rPr kumimoji="1" lang="en-US" altLang="ja-JP" dirty="0"/>
              <a:t>...2=Men   0.11 </a:t>
            </a:r>
            <a:r>
              <a:rPr kumimoji="1" lang="ja-JP" altLang="en-US" dirty="0"/>
              <a:t>　　</a:t>
            </a:r>
            <a:r>
              <a:rPr kumimoji="1" lang="en-US" altLang="ja-JP" dirty="0"/>
              <a:t>0.115       0.13 </a:t>
            </a:r>
            <a:r>
              <a:rPr kumimoji="1" lang="ja-JP" altLang="en-US" dirty="0"/>
              <a:t>　　　</a:t>
            </a:r>
            <a:r>
              <a:rPr kumimoji="1" lang="en-US" altLang="ja-JP" dirty="0"/>
              <a:t>0.135 </a:t>
            </a:r>
            <a:r>
              <a:rPr kumimoji="1" lang="ja-JP" altLang="en-US" dirty="0"/>
              <a:t>　　　</a:t>
            </a:r>
            <a:r>
              <a:rPr kumimoji="1" lang="en-US" altLang="ja-JP" dirty="0"/>
              <a:t>0.16 </a:t>
            </a:r>
            <a:r>
              <a:rPr kumimoji="1" lang="ja-JP" altLang="en-US" dirty="0"/>
              <a:t>　　　　</a:t>
            </a:r>
            <a:r>
              <a:rPr kumimoji="1" lang="en-US" altLang="ja-JP" dirty="0"/>
              <a:t>0.0024</a:t>
            </a:r>
          </a:p>
          <a:p>
            <a:r>
              <a:rPr kumimoji="1" lang="en-US" altLang="ja-JP" dirty="0"/>
              <a:t>...2=Women 0.08 </a:t>
            </a:r>
            <a:r>
              <a:rPr kumimoji="1" lang="ja-JP" altLang="en-US" dirty="0"/>
              <a:t>　</a:t>
            </a:r>
            <a:r>
              <a:rPr kumimoji="1" lang="en-US" altLang="ja-JP" dirty="0"/>
              <a:t>0.090      0.09 </a:t>
            </a:r>
            <a:r>
              <a:rPr kumimoji="1" lang="ja-JP" altLang="en-US" dirty="0"/>
              <a:t>　　　</a:t>
            </a:r>
            <a:r>
              <a:rPr kumimoji="1" lang="en-US" altLang="ja-JP" dirty="0"/>
              <a:t>0.100</a:t>
            </a:r>
            <a:r>
              <a:rPr kumimoji="1" lang="ja-JP" altLang="en-US" dirty="0"/>
              <a:t>　　　</a:t>
            </a:r>
            <a:r>
              <a:rPr kumimoji="1" lang="en-US" altLang="ja-JP" dirty="0"/>
              <a:t> 0.11       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208400-57EC-4A3F-9FBC-DD658FA20C0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75388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&gt; D &lt;- </a:t>
            </a:r>
          </a:p>
          <a:p>
            <a:r>
              <a:rPr kumimoji="1" lang="en-US" altLang="ja-JP" dirty="0"/>
              <a:t>+   </a:t>
            </a:r>
            <a:r>
              <a:rPr kumimoji="1" lang="en-US" altLang="ja-JP" dirty="0" err="1"/>
              <a:t>readXL</a:t>
            </a:r>
            <a:r>
              <a:rPr kumimoji="1" lang="en-US" altLang="ja-JP" dirty="0"/>
              <a:t>("C:/Users/akazawa hidemasa/OneDrive/</a:t>
            </a:r>
            <a:r>
              <a:rPr kumimoji="1" lang="ja-JP" altLang="en-US" dirty="0"/>
              <a:t>デスクトップ</a:t>
            </a:r>
            <a:r>
              <a:rPr kumimoji="1" lang="en-US" altLang="ja-JP" dirty="0"/>
              <a:t>/</a:t>
            </a:r>
            <a:r>
              <a:rPr kumimoji="1" lang="ja-JP" altLang="en-US" dirty="0"/>
              <a:t>クリプトコックス</a:t>
            </a:r>
            <a:r>
              <a:rPr kumimoji="1" lang="en-US" altLang="ja-JP" dirty="0"/>
              <a:t>/o70 region KWT.xlsx",</a:t>
            </a:r>
          </a:p>
          <a:p>
            <a:r>
              <a:rPr kumimoji="1" lang="en-US" altLang="ja-JP" dirty="0"/>
              <a:t>+    </a:t>
            </a:r>
            <a:r>
              <a:rPr kumimoji="1" lang="en-US" altLang="ja-JP" dirty="0" err="1"/>
              <a:t>rownames</a:t>
            </a:r>
            <a:r>
              <a:rPr kumimoji="1" lang="en-US" altLang="ja-JP" dirty="0"/>
              <a:t>=FALSE, header=TRUE, </a:t>
            </a:r>
            <a:r>
              <a:rPr kumimoji="1" lang="en-US" altLang="ja-JP" dirty="0" err="1"/>
              <a:t>na</a:t>
            </a:r>
            <a:r>
              <a:rPr kumimoji="1" lang="en-US" altLang="ja-JP" dirty="0"/>
              <a:t>="", sheet="Sheet1", </a:t>
            </a:r>
            <a:r>
              <a:rPr kumimoji="1" lang="en-US" altLang="ja-JP" dirty="0" err="1"/>
              <a:t>stringsAsFactors</a:t>
            </a:r>
            <a:r>
              <a:rPr kumimoji="1" lang="en-US" altLang="ja-JP" dirty="0"/>
              <a:t>=TRUE)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&gt; #####3</a:t>
            </a:r>
            <a:r>
              <a:rPr kumimoji="1" lang="ja-JP" altLang="en-US" dirty="0"/>
              <a:t>群以上の間の比較</a:t>
            </a:r>
            <a:r>
              <a:rPr kumimoji="1" lang="en-US" altLang="ja-JP" dirty="0"/>
              <a:t>(Kruskal-Wallis</a:t>
            </a:r>
            <a:r>
              <a:rPr kumimoji="1" lang="ja-JP" altLang="en-US" dirty="0"/>
              <a:t>検定</a:t>
            </a:r>
            <a:r>
              <a:rPr kumimoji="1" lang="en-US" altLang="ja-JP" dirty="0"/>
              <a:t>)#####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&gt; windows(width=7, height=7); par(</a:t>
            </a:r>
            <a:r>
              <a:rPr kumimoji="1" lang="en-US" altLang="ja-JP" dirty="0" err="1"/>
              <a:t>lwd</a:t>
            </a:r>
            <a:r>
              <a:rPr kumimoji="1" lang="en-US" altLang="ja-JP" dirty="0"/>
              <a:t>=1, las=1, family="sans", </a:t>
            </a:r>
            <a:r>
              <a:rPr kumimoji="1" lang="en-US" altLang="ja-JP" dirty="0" err="1"/>
              <a:t>cex</a:t>
            </a:r>
            <a:r>
              <a:rPr kumimoji="1" lang="en-US" altLang="ja-JP" dirty="0"/>
              <a:t>=1, </a:t>
            </a:r>
            <a:r>
              <a:rPr kumimoji="1" lang="en-US" altLang="ja-JP" dirty="0" err="1"/>
              <a:t>mgp</a:t>
            </a:r>
            <a:r>
              <a:rPr kumimoji="1" lang="en-US" altLang="ja-JP" dirty="0"/>
              <a:t>=c(3.0,1,0))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&gt; boxplot(</a:t>
            </a:r>
            <a:r>
              <a:rPr kumimoji="1" lang="en-US" altLang="ja-JP" dirty="0" err="1"/>
              <a:t>Crude.rate</a:t>
            </a:r>
            <a:r>
              <a:rPr kumimoji="1" lang="en-US" altLang="ja-JP" dirty="0"/>
              <a:t>~ factor(Region), </a:t>
            </a:r>
            <a:r>
              <a:rPr kumimoji="1" lang="en-US" altLang="ja-JP" dirty="0" err="1"/>
              <a:t>ylab</a:t>
            </a:r>
            <a:r>
              <a:rPr kumimoji="1" lang="en-US" altLang="ja-JP" dirty="0"/>
              <a:t>="</a:t>
            </a:r>
            <a:r>
              <a:rPr kumimoji="1" lang="en-US" altLang="ja-JP" dirty="0" err="1"/>
              <a:t>Crude.rate</a:t>
            </a:r>
            <a:r>
              <a:rPr kumimoji="1" lang="en-US" altLang="ja-JP" dirty="0"/>
              <a:t>", </a:t>
            </a:r>
            <a:r>
              <a:rPr kumimoji="1" lang="en-US" altLang="ja-JP" dirty="0" err="1"/>
              <a:t>xlab</a:t>
            </a:r>
            <a:r>
              <a:rPr kumimoji="1" lang="en-US" altLang="ja-JP" dirty="0"/>
              <a:t>="Region", data=D)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&gt; </a:t>
            </a:r>
            <a:r>
              <a:rPr kumimoji="1" lang="en-US" altLang="ja-JP" dirty="0" err="1"/>
              <a:t>tapply</a:t>
            </a:r>
            <a:r>
              <a:rPr kumimoji="1" lang="en-US" altLang="ja-JP" dirty="0"/>
              <a:t>(</a:t>
            </a:r>
            <a:r>
              <a:rPr kumimoji="1" lang="en-US" altLang="ja-JP" dirty="0" err="1"/>
              <a:t>D$Crude.rate</a:t>
            </a:r>
            <a:r>
              <a:rPr kumimoji="1" lang="en-US" altLang="ja-JP" dirty="0"/>
              <a:t>, </a:t>
            </a:r>
            <a:r>
              <a:rPr kumimoji="1" lang="en-US" altLang="ja-JP" dirty="0" err="1"/>
              <a:t>D$Region</a:t>
            </a:r>
            <a:r>
              <a:rPr kumimoji="1" lang="en-US" altLang="ja-JP" dirty="0"/>
              <a:t>, median, na.rm=TRUE)</a:t>
            </a:r>
          </a:p>
          <a:p>
            <a:r>
              <a:rPr kumimoji="1" lang="en-US" altLang="ja-JP" dirty="0"/>
              <a:t> Eastern Japan Northern Japan Southern Japan  Western Japan </a:t>
            </a:r>
          </a:p>
          <a:p>
            <a:r>
              <a:rPr kumimoji="1" lang="en-US" altLang="ja-JP" dirty="0"/>
              <a:t>     0.4156153      0.2077151      0.4598514      0.3609178 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&gt; res &lt;- NULL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&gt; (res &lt;- </a:t>
            </a:r>
            <a:r>
              <a:rPr kumimoji="1" lang="en-US" altLang="ja-JP" dirty="0" err="1"/>
              <a:t>kruskal.test</a:t>
            </a:r>
            <a:r>
              <a:rPr kumimoji="1" lang="en-US" altLang="ja-JP" dirty="0"/>
              <a:t>(</a:t>
            </a:r>
            <a:r>
              <a:rPr kumimoji="1" lang="en-US" altLang="ja-JP" dirty="0" err="1"/>
              <a:t>Crude.rate</a:t>
            </a:r>
            <a:r>
              <a:rPr kumimoji="1" lang="en-US" altLang="ja-JP" dirty="0"/>
              <a:t> ~ factor(Region), data=D))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	Kruskal-Wallis rank sum test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data:  </a:t>
            </a:r>
            <a:r>
              <a:rPr kumimoji="1" lang="en-US" altLang="ja-JP" dirty="0" err="1"/>
              <a:t>Crude.rate</a:t>
            </a:r>
            <a:r>
              <a:rPr kumimoji="1" lang="en-US" altLang="ja-JP" dirty="0"/>
              <a:t> by factor(Region)</a:t>
            </a:r>
          </a:p>
          <a:p>
            <a:r>
              <a:rPr kumimoji="1" lang="en-US" altLang="ja-JP" dirty="0"/>
              <a:t>Kruskal-Wallis chi-squared = 16.22, </a:t>
            </a:r>
            <a:r>
              <a:rPr kumimoji="1" lang="en-US" altLang="ja-JP" dirty="0" err="1"/>
              <a:t>df</a:t>
            </a:r>
            <a:r>
              <a:rPr kumimoji="1" lang="en-US" altLang="ja-JP" dirty="0"/>
              <a:t> = 3, p-value = 0.001022</a:t>
            </a:r>
          </a:p>
          <a:p>
            <a:endParaRPr kumimoji="1" lang="en-US" altLang="ja-JP" dirty="0"/>
          </a:p>
          <a:p>
            <a:endParaRPr kumimoji="1" lang="en-US" altLang="ja-JP" dirty="0"/>
          </a:p>
          <a:p>
            <a:r>
              <a:rPr kumimoji="1" lang="en-US" altLang="ja-JP" dirty="0"/>
              <a:t>&gt; cat(</a:t>
            </a:r>
            <a:r>
              <a:rPr kumimoji="1" lang="en-US" altLang="ja-JP" dirty="0" err="1"/>
              <a:t>gettextRcmdr</a:t>
            </a:r>
            <a:r>
              <a:rPr kumimoji="1" lang="en-US" altLang="ja-JP" dirty="0"/>
              <a:t>( "Kruskal-Wallis test"), " ", </a:t>
            </a:r>
            <a:r>
              <a:rPr kumimoji="1" lang="en-US" altLang="ja-JP" dirty="0" err="1"/>
              <a:t>gettextRcmdr</a:t>
            </a:r>
            <a:r>
              <a:rPr kumimoji="1" lang="en-US" altLang="ja-JP" dirty="0"/>
              <a:t>( "</a:t>
            </a:r>
            <a:r>
              <a:rPr kumimoji="1" lang="en-US" altLang="ja-JP" dirty="0" err="1"/>
              <a:t>p.value</a:t>
            </a:r>
            <a:r>
              <a:rPr kumimoji="1" lang="en-US" altLang="ja-JP" dirty="0"/>
              <a:t>"), " = ", </a:t>
            </a:r>
            <a:r>
              <a:rPr kumimoji="1" lang="en-US" altLang="ja-JP" dirty="0" err="1"/>
              <a:t>signif</a:t>
            </a:r>
            <a:r>
              <a:rPr kumimoji="1" lang="en-US" altLang="ja-JP" dirty="0"/>
              <a:t>(</a:t>
            </a:r>
            <a:r>
              <a:rPr kumimoji="1" lang="en-US" altLang="ja-JP" dirty="0" err="1"/>
              <a:t>res$p.value</a:t>
            </a:r>
            <a:r>
              <a:rPr kumimoji="1" lang="en-US" altLang="ja-JP" dirty="0"/>
              <a:t>, digits=3), "</a:t>
            </a:r>
          </a:p>
          <a:p>
            <a:r>
              <a:rPr kumimoji="1" lang="en-US" altLang="ja-JP" dirty="0"/>
              <a:t>+ ", </a:t>
            </a:r>
            <a:r>
              <a:rPr kumimoji="1" lang="en-US" altLang="ja-JP" dirty="0" err="1"/>
              <a:t>sep</a:t>
            </a:r>
            <a:r>
              <a:rPr kumimoji="1" lang="en-US" altLang="ja-JP" dirty="0"/>
              <a:t>="")</a:t>
            </a:r>
          </a:p>
          <a:p>
            <a:r>
              <a:rPr kumimoji="1" lang="en-US" altLang="ja-JP" dirty="0"/>
              <a:t>3</a:t>
            </a:r>
            <a:r>
              <a:rPr kumimoji="1" lang="ja-JP" altLang="en-US" dirty="0"/>
              <a:t>群以上の間の比較</a:t>
            </a:r>
            <a:r>
              <a:rPr kumimoji="1" lang="en-US" altLang="ja-JP" dirty="0"/>
              <a:t>(Kruskal-Wallis</a:t>
            </a:r>
            <a:r>
              <a:rPr kumimoji="1" lang="ja-JP" altLang="en-US" dirty="0"/>
              <a:t>検定</a:t>
            </a:r>
            <a:r>
              <a:rPr kumimoji="1" lang="en-US" altLang="ja-JP" dirty="0"/>
              <a:t>) P</a:t>
            </a:r>
            <a:r>
              <a:rPr kumimoji="1" lang="ja-JP" altLang="en-US" dirty="0"/>
              <a:t>値 </a:t>
            </a:r>
            <a:r>
              <a:rPr kumimoji="1" lang="en-US" altLang="ja-JP" dirty="0"/>
              <a:t>= 0.00102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&gt; </a:t>
            </a:r>
            <a:r>
              <a:rPr kumimoji="1" lang="en-US" altLang="ja-JP" dirty="0" err="1"/>
              <a:t>pairwise.kruskal.test</a:t>
            </a:r>
            <a:r>
              <a:rPr kumimoji="1" lang="en-US" altLang="ja-JP" dirty="0"/>
              <a:t>(</a:t>
            </a:r>
            <a:r>
              <a:rPr kumimoji="1" lang="en-US" altLang="ja-JP" dirty="0" err="1"/>
              <a:t>D$Crude.rate</a:t>
            </a:r>
            <a:r>
              <a:rPr kumimoji="1" lang="en-US" altLang="ja-JP" dirty="0"/>
              <a:t>, </a:t>
            </a:r>
            <a:r>
              <a:rPr kumimoji="1" lang="en-US" altLang="ja-JP" dirty="0" err="1"/>
              <a:t>D$Region</a:t>
            </a:r>
            <a:r>
              <a:rPr kumimoji="1" lang="en-US" altLang="ja-JP" dirty="0"/>
              <a:t>, data.name="D", </a:t>
            </a:r>
            <a:r>
              <a:rPr kumimoji="1" lang="en-US" altLang="ja-JP" dirty="0" err="1"/>
              <a:t>p.adjust.method</a:t>
            </a:r>
            <a:r>
              <a:rPr kumimoji="1" lang="en-US" altLang="ja-JP" dirty="0"/>
              <a:t>="</a:t>
            </a:r>
            <a:r>
              <a:rPr kumimoji="1" lang="en-US" altLang="ja-JP" dirty="0" err="1"/>
              <a:t>bonferroni</a:t>
            </a:r>
            <a:r>
              <a:rPr kumimoji="1" lang="en-US" altLang="ja-JP" dirty="0"/>
              <a:t>")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	Pairwise comparisons using Mann-Whitney U test 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data:  D 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               Eastern Japan Northern Japan Southern Japan</a:t>
            </a:r>
          </a:p>
          <a:p>
            <a:r>
              <a:rPr kumimoji="1" lang="en-US" altLang="ja-JP" dirty="0"/>
              <a:t>Northern Japan 0.0035        -              -             </a:t>
            </a:r>
          </a:p>
          <a:p>
            <a:r>
              <a:rPr kumimoji="1" lang="en-US" altLang="ja-JP" dirty="0"/>
              <a:t>Southern Japan 1.0000        0.0128         -             </a:t>
            </a:r>
          </a:p>
          <a:p>
            <a:r>
              <a:rPr kumimoji="1" lang="en-US" altLang="ja-JP" dirty="0"/>
              <a:t>Western Japan  1.0000        0.0070         1.0000        </a:t>
            </a:r>
          </a:p>
          <a:p>
            <a:endParaRPr kumimoji="1" lang="en-US" altLang="ja-JP" dirty="0"/>
          </a:p>
          <a:p>
            <a:r>
              <a:rPr kumimoji="1" lang="en-US" altLang="ja-JP" dirty="0"/>
              <a:t>P value adjustment method: </a:t>
            </a:r>
            <a:r>
              <a:rPr kumimoji="1" lang="en-US" altLang="ja-JP" dirty="0" err="1"/>
              <a:t>bonferroni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BC5566-14A5-414A-9C54-D33835726B58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61118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5F5A32-9D51-8EA0-60DD-AA2097DD89C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25FF891-D5F1-EEEA-3190-FD52601BD3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F80500-6E61-B79B-60CB-D900151A9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425EE9-8918-55CA-7A3B-DA8F732BA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51C0DD-2808-82E5-633F-B96E62BE3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21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4F90F0-3BDF-25F1-F19B-C359841118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A9713EC-EC18-C32D-5E69-8AE6CEED0F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5252E39-3289-0630-AE45-3CAB7C683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D15373-D15F-08BF-06DD-5F6F2F11B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7FE8EB-7B63-00C4-4D2C-B2B4808A5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224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FC53E9C-7622-B4BD-6BD3-AD47110DD7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EC4C605-E3BF-D583-051D-2A4F60F322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F7973BA-EF28-3E4A-4F55-EF053F26A8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587EAE-5083-B0A9-141D-C46BEC6774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76BB56-6BC9-CBA2-713B-4366E74CE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2936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F87F7C-69E9-967E-B460-A81810DBD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F0DFB7-43C3-F030-3391-90EA128E05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A3796D-5152-7F9D-928E-390E32EE8C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68B98D9-6C09-B234-86E5-67787DF33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FCBE2F-9953-568C-0D44-881046A38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124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6546EE-752F-1083-5E51-584D0C7710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6A7FA2A-1C3B-07BF-1C7C-7194100216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0005FC-FEED-E510-517D-B4826D032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052696-DEED-6DD2-713E-964853911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B0D110-BEDF-0AFF-B57C-4FA899408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6047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4298F7-EBF3-AFD3-33EF-ED968F5D7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DBE7A2C-7766-1A4F-ED37-6C13E7AA11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3DEC31E-5C49-3A77-26AA-36DBDCD936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A3AEB3F-2987-DEE1-0976-D535826E4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4425765-07E5-4680-FB2B-A601EF8BA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5F0A20C-59EB-CC62-D8CC-72FD9791F9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9334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82B951-CAC1-0D8F-0B3B-80A1BCAC99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7D1E278-862B-F547-6CF7-303C8D60F9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3DC83FB-3CA0-8596-65B3-846B810BBE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6806CA3-5AE3-170B-E2D9-E906FB90ED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C9230A4-CA11-278F-D0C7-B9CB2E1949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C89EB01-85C9-D6FF-F189-25E11525E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8E30090-08CE-9459-8CC4-54BC43BD2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63F788E-47EA-07D6-6B4D-49C15B1AFB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433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5981E7-4D0C-F2D4-938C-FA13C08976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6AA711F-3D6F-16C6-1E0F-8B69D7435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A9DABC3-2053-FC24-1587-ED05F6B8D2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D1F2AEF-F1CC-8881-CF2B-D7702D667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573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EF89AF2-D511-AC92-8263-8C0DD6E52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9A766B7-84B2-C916-90B3-1425C76F4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B46F80D-CD31-B2CC-0E40-69BBE38DC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594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9708E0-62AC-10FB-7575-39DC7DE1C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D392485-6A7D-1765-47BB-B7DDE0E337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9AB25A-8CA7-9FCA-B52B-BD58B10489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EEB1089-80D9-CB28-A0D4-BC892FD01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05FA25D-07A6-C85E-E062-8D274E73B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0A96977-FE71-1D02-3423-ADE57D1B9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5260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D17099-5900-91DA-6F08-B7E142C18B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53A7BC0-DDA4-582B-2D30-DEECC4183E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4124066-46FF-5E96-7071-1AE901610F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0537A0D-635C-B131-642B-54976C771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0FCCA2E-E373-F775-FAA8-417A88186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00ACB0F-9743-A2FA-9838-22DB93B24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8268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BAEBE05-42FE-4DAB-0104-87941430A0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E63EA13-7304-A020-3B9A-CDCC862B38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1EFD01-40A5-B8A2-4973-B54D80B54B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C84AB-319A-4228-99BF-89FB8BE3F575}" type="datetimeFigureOut">
              <a:rPr kumimoji="1" lang="ja-JP" altLang="en-US" smtClean="0"/>
              <a:t>2023/10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8E6564-0A1B-FDD1-C820-70DCE857A7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00D6361-0BD4-9175-EA03-E627ADDDDA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63E5F-C2B3-4E75-868A-567F429558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0931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14/relationships/chartEx" Target="../charts/chartEx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6BF8B3C-DF8A-41C8-1A4E-B45DD4426523}"/>
              </a:ext>
            </a:extLst>
          </p:cNvPr>
          <p:cNvSpPr txBox="1"/>
          <p:nvPr/>
        </p:nvSpPr>
        <p:spPr>
          <a:xfrm>
            <a:off x="0" y="0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Supplementary Figure 1. </a:t>
            </a:r>
            <a:r>
              <a:rPr lang="en-US" altLang="ja-JP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Crude incidence</a:t>
            </a:r>
            <a:r>
              <a:rPr lang="ja-JP" altLang="en-US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 </a:t>
            </a:r>
            <a:r>
              <a:rPr lang="en-US" altLang="ja-JP" b="1" dirty="0">
                <a:solidFill>
                  <a:prstClr val="black"/>
                </a:solidFill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rate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 of disseminated cryptococcosis in Japan between 2015 and 2021, by 10-year age group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メイリオ"/>
              <a:cs typeface="Times New Roman" panose="02020603050405020304" pitchFamily="18" charset="0"/>
            </a:endParaRPr>
          </a:p>
        </p:txBody>
      </p:sp>
      <mc:AlternateContent xmlns:mc="http://schemas.openxmlformats.org/markup-compatibility/2006" xmlns:cx1="http://schemas.microsoft.com/office/drawing/2015/9/8/chartex">
        <mc:Choice Requires="cx1">
          <p:graphicFrame>
            <p:nvGraphicFramePr>
              <p:cNvPr id="2" name="グラフ 1">
                <a:extLst>
                  <a:ext uri="{FF2B5EF4-FFF2-40B4-BE49-F238E27FC236}">
                    <a16:creationId xmlns:a16="http://schemas.microsoft.com/office/drawing/2014/main" id="{13F30BCE-E192-51C0-9470-34E86DEFA342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684943227"/>
                  </p:ext>
                </p:extLst>
              </p:nvPr>
            </p:nvGraphicFramePr>
            <p:xfrm>
              <a:off x="2676000" y="1221272"/>
              <a:ext cx="6840000" cy="4680000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 xmlns="">
          <p:pic>
            <p:nvPicPr>
              <p:cNvPr id="2" name="グラフ 1">
                <a:extLst>
                  <a:ext uri="{FF2B5EF4-FFF2-40B4-BE49-F238E27FC236}">
                    <a16:creationId xmlns:a16="http://schemas.microsoft.com/office/drawing/2014/main" id="{13F30BCE-E192-51C0-9470-34E86DEFA342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676000" y="1221272"/>
                <a:ext cx="6840000" cy="4680000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25642682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5849A58-6E95-6A0F-9BA3-80A64B3FB3B0}"/>
              </a:ext>
            </a:extLst>
          </p:cNvPr>
          <p:cNvSpPr txBox="1"/>
          <p:nvPr/>
        </p:nvSpPr>
        <p:spPr>
          <a:xfrm>
            <a:off x="0" y="0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Supplementary Figure 2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 difference of the age-adjusted incidence rates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AR)</a:t>
            </a:r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disseminated cryptococcosis 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Japan 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2015 and 2021</a:t>
            </a:r>
          </a:p>
        </p:txBody>
      </p: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245AC229-0022-C886-7ED4-0594B9B585AD}"/>
              </a:ext>
            </a:extLst>
          </p:cNvPr>
          <p:cNvGrpSpPr/>
          <p:nvPr/>
        </p:nvGrpSpPr>
        <p:grpSpPr>
          <a:xfrm>
            <a:off x="2862849" y="436294"/>
            <a:ext cx="6444000" cy="5400000"/>
            <a:chOff x="2234611" y="858271"/>
            <a:chExt cx="6466302" cy="5573726"/>
          </a:xfrm>
        </p:grpSpPr>
        <p:grpSp>
          <p:nvGrpSpPr>
            <p:cNvPr id="41" name="グループ化 40">
              <a:extLst>
                <a:ext uri="{FF2B5EF4-FFF2-40B4-BE49-F238E27FC236}">
                  <a16:creationId xmlns:a16="http://schemas.microsoft.com/office/drawing/2014/main" id="{77D335CC-22AB-3792-D7E9-272BB99004AA}"/>
                </a:ext>
              </a:extLst>
            </p:cNvPr>
            <p:cNvGrpSpPr/>
            <p:nvPr/>
          </p:nvGrpSpPr>
          <p:grpSpPr>
            <a:xfrm>
              <a:off x="2234611" y="1645323"/>
              <a:ext cx="6466302" cy="4786674"/>
              <a:chOff x="3136954" y="521879"/>
              <a:chExt cx="3423415" cy="2846085"/>
            </a:xfrm>
          </p:grpSpPr>
          <p:sp>
            <p:nvSpPr>
              <p:cNvPr id="8" name="Rectangle 5">
                <a:extLst>
                  <a:ext uri="{FF2B5EF4-FFF2-40B4-BE49-F238E27FC236}">
                    <a16:creationId xmlns:a16="http://schemas.microsoft.com/office/drawing/2014/main" id="{1FCC9E85-61BE-8900-F082-8AF1E08C16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7981" y="1347379"/>
                <a:ext cx="1050925" cy="587375"/>
              </a:xfrm>
              <a:prstGeom prst="rect">
                <a:avLst/>
              </a:prstGeom>
              <a:solidFill>
                <a:srgbClr val="D3D3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" name="Line 6">
                <a:extLst>
                  <a:ext uri="{FF2B5EF4-FFF2-40B4-BE49-F238E27FC236}">
                    <a16:creationId xmlns:a16="http://schemas.microsoft.com/office/drawing/2014/main" id="{B0DA0EAA-C450-50E7-8977-823CAC483D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67981" y="1496604"/>
                <a:ext cx="1050925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" name="Freeform 7">
                <a:extLst>
                  <a:ext uri="{FF2B5EF4-FFF2-40B4-BE49-F238E27FC236}">
                    <a16:creationId xmlns:a16="http://schemas.microsoft.com/office/drawing/2014/main" id="{8B7385F5-57C0-838F-7A0F-4FABD7510CFD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493443" y="1934754"/>
                <a:ext cx="0" cy="127000"/>
              </a:xfrm>
              <a:custGeom>
                <a:avLst/>
                <a:gdLst>
                  <a:gd name="T0" fmla="*/ 25 h 25"/>
                  <a:gd name="T1" fmla="*/ 21 h 25"/>
                  <a:gd name="T2" fmla="*/ 17 h 25"/>
                  <a:gd name="T3" fmla="*/ 13 h 25"/>
                  <a:gd name="T4" fmla="*/ 9 h 25"/>
                  <a:gd name="T5" fmla="*/ 5 h 25"/>
                  <a:gd name="T6" fmla="*/ 1 h 2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</a:cxnLst>
                <a:rect l="0" t="0" r="r" b="b"/>
                <a:pathLst>
                  <a:path h="25">
                    <a:moveTo>
                      <a:pt x="0" y="21"/>
                    </a:moveTo>
                    <a:lnTo>
                      <a:pt x="0" y="17"/>
                    </a:lnTo>
                    <a:moveTo>
                      <a:pt x="0" y="13"/>
                    </a:moveTo>
                    <a:lnTo>
                      <a:pt x="0" y="9"/>
                    </a:lnTo>
                    <a:moveTo>
                      <a:pt x="0" y="5"/>
                    </a:moveTo>
                    <a:lnTo>
                      <a:pt x="0" y="1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" name="Freeform 8">
                <a:extLst>
                  <a:ext uri="{FF2B5EF4-FFF2-40B4-BE49-F238E27FC236}">
                    <a16:creationId xmlns:a16="http://schemas.microsoft.com/office/drawing/2014/main" id="{09DF674B-C1A6-9F28-EC68-79650F2CB575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493443" y="639354"/>
                <a:ext cx="0" cy="708025"/>
              </a:xfrm>
              <a:custGeom>
                <a:avLst/>
                <a:gdLst>
                  <a:gd name="T0" fmla="*/ 0 h 139"/>
                  <a:gd name="T1" fmla="*/ 4 h 139"/>
                  <a:gd name="T2" fmla="*/ 8 h 139"/>
                  <a:gd name="T3" fmla="*/ 12 h 139"/>
                  <a:gd name="T4" fmla="*/ 16 h 139"/>
                  <a:gd name="T5" fmla="*/ 20 h 139"/>
                  <a:gd name="T6" fmla="*/ 24 h 139"/>
                  <a:gd name="T7" fmla="*/ 28 h 139"/>
                  <a:gd name="T8" fmla="*/ 32 h 139"/>
                  <a:gd name="T9" fmla="*/ 36 h 139"/>
                  <a:gd name="T10" fmla="*/ 40 h 139"/>
                  <a:gd name="T11" fmla="*/ 44 h 139"/>
                  <a:gd name="T12" fmla="*/ 48 h 139"/>
                  <a:gd name="T13" fmla="*/ 52 h 139"/>
                  <a:gd name="T14" fmla="*/ 56 h 139"/>
                  <a:gd name="T15" fmla="*/ 60 h 139"/>
                  <a:gd name="T16" fmla="*/ 64 h 139"/>
                  <a:gd name="T17" fmla="*/ 68 h 139"/>
                  <a:gd name="T18" fmla="*/ 72 h 139"/>
                  <a:gd name="T19" fmla="*/ 76 h 139"/>
                  <a:gd name="T20" fmla="*/ 80 h 139"/>
                  <a:gd name="T21" fmla="*/ 84 h 139"/>
                  <a:gd name="T22" fmla="*/ 88 h 139"/>
                  <a:gd name="T23" fmla="*/ 92 h 139"/>
                  <a:gd name="T24" fmla="*/ 96 h 139"/>
                  <a:gd name="T25" fmla="*/ 100 h 139"/>
                  <a:gd name="T26" fmla="*/ 104 h 139"/>
                  <a:gd name="T27" fmla="*/ 108 h 139"/>
                  <a:gd name="T28" fmla="*/ 112 h 139"/>
                  <a:gd name="T29" fmla="*/ 116 h 139"/>
                  <a:gd name="T30" fmla="*/ 120 h 139"/>
                  <a:gd name="T31" fmla="*/ 124 h 139"/>
                  <a:gd name="T32" fmla="*/ 128 h 139"/>
                  <a:gd name="T33" fmla="*/ 132 h 139"/>
                  <a:gd name="T34" fmla="*/ 136 h 13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</a:cxnLst>
                <a:rect l="0" t="0" r="r" b="b"/>
                <a:pathLst>
                  <a:path h="13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  <a:moveTo>
                      <a:pt x="0" y="100"/>
                    </a:moveTo>
                    <a:lnTo>
                      <a:pt x="0" y="104"/>
                    </a:lnTo>
                    <a:moveTo>
                      <a:pt x="0" y="108"/>
                    </a:moveTo>
                    <a:lnTo>
                      <a:pt x="0" y="112"/>
                    </a:lnTo>
                    <a:moveTo>
                      <a:pt x="0" y="116"/>
                    </a:moveTo>
                    <a:lnTo>
                      <a:pt x="0" y="120"/>
                    </a:lnTo>
                    <a:moveTo>
                      <a:pt x="0" y="124"/>
                    </a:moveTo>
                    <a:lnTo>
                      <a:pt x="0" y="128"/>
                    </a:lnTo>
                    <a:moveTo>
                      <a:pt x="0" y="132"/>
                    </a:moveTo>
                    <a:lnTo>
                      <a:pt x="0" y="136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2" name="Line 9">
                <a:extLst>
                  <a:ext uri="{FF2B5EF4-FFF2-40B4-BE49-F238E27FC236}">
                    <a16:creationId xmlns:a16="http://schemas.microsoft.com/office/drawing/2014/main" id="{39537CF2-F3A4-BE85-4EF4-08D046A76B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33093" y="2082391"/>
                <a:ext cx="5207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3" name="Line 10">
                <a:extLst>
                  <a:ext uri="{FF2B5EF4-FFF2-40B4-BE49-F238E27FC236}">
                    <a16:creationId xmlns:a16="http://schemas.microsoft.com/office/drawing/2014/main" id="{DE82D05D-E6B3-0924-C4A8-F6CA6B5EB3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33093" y="618716"/>
                <a:ext cx="5207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4" name="Rectangle 11">
                <a:extLst>
                  <a:ext uri="{FF2B5EF4-FFF2-40B4-BE49-F238E27FC236}">
                    <a16:creationId xmlns:a16="http://schemas.microsoft.com/office/drawing/2014/main" id="{7A8FA9A5-76F7-8618-C44E-7CBB01876A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7981" y="1347379"/>
                <a:ext cx="1050925" cy="587375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5" name="Rectangle 12">
                <a:extLst>
                  <a:ext uri="{FF2B5EF4-FFF2-40B4-BE49-F238E27FC236}">
                    <a16:creationId xmlns:a16="http://schemas.microsoft.com/office/drawing/2014/main" id="{A191B6B3-517B-0635-E0C4-F7AA1D7CA3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79256" y="2374491"/>
                <a:ext cx="1046163" cy="295275"/>
              </a:xfrm>
              <a:prstGeom prst="rect">
                <a:avLst/>
              </a:prstGeom>
              <a:solidFill>
                <a:srgbClr val="D3D3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6" name="Line 13">
                <a:extLst>
                  <a:ext uri="{FF2B5EF4-FFF2-40B4-BE49-F238E27FC236}">
                    <a16:creationId xmlns:a16="http://schemas.microsoft.com/office/drawing/2014/main" id="{753ECEDF-DBFD-7549-AD6C-91D87A7FC3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79256" y="2669766"/>
                <a:ext cx="1046163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7" name="Freeform 14">
                <a:extLst>
                  <a:ext uri="{FF2B5EF4-FFF2-40B4-BE49-F238E27FC236}">
                    <a16:creationId xmlns:a16="http://schemas.microsoft.com/office/drawing/2014/main" id="{67F8BC9C-191A-5F2C-770D-2B7E4718403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799956" y="2669766"/>
                <a:ext cx="0" cy="269875"/>
              </a:xfrm>
              <a:custGeom>
                <a:avLst/>
                <a:gdLst>
                  <a:gd name="T0" fmla="*/ 53 h 53"/>
                  <a:gd name="T1" fmla="*/ 49 h 53"/>
                  <a:gd name="T2" fmla="*/ 45 h 53"/>
                  <a:gd name="T3" fmla="*/ 41 h 53"/>
                  <a:gd name="T4" fmla="*/ 37 h 53"/>
                  <a:gd name="T5" fmla="*/ 33 h 53"/>
                  <a:gd name="T6" fmla="*/ 29 h 53"/>
                  <a:gd name="T7" fmla="*/ 25 h 53"/>
                  <a:gd name="T8" fmla="*/ 21 h 53"/>
                  <a:gd name="T9" fmla="*/ 17 h 53"/>
                  <a:gd name="T10" fmla="*/ 13 h 53"/>
                  <a:gd name="T11" fmla="*/ 9 h 53"/>
                  <a:gd name="T12" fmla="*/ 5 h 53"/>
                  <a:gd name="T13" fmla="*/ 1 h 5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</a:cxnLst>
                <a:rect l="0" t="0" r="r" b="b"/>
                <a:pathLst>
                  <a:path h="53">
                    <a:moveTo>
                      <a:pt x="0" y="49"/>
                    </a:moveTo>
                    <a:lnTo>
                      <a:pt x="0" y="45"/>
                    </a:lnTo>
                    <a:moveTo>
                      <a:pt x="0" y="41"/>
                    </a:moveTo>
                    <a:lnTo>
                      <a:pt x="0" y="37"/>
                    </a:lnTo>
                    <a:moveTo>
                      <a:pt x="0" y="33"/>
                    </a:moveTo>
                    <a:lnTo>
                      <a:pt x="0" y="29"/>
                    </a:lnTo>
                    <a:moveTo>
                      <a:pt x="0" y="25"/>
                    </a:moveTo>
                    <a:lnTo>
                      <a:pt x="0" y="21"/>
                    </a:lnTo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" name="Freeform 15">
                <a:extLst>
                  <a:ext uri="{FF2B5EF4-FFF2-40B4-BE49-F238E27FC236}">
                    <a16:creationId xmlns:a16="http://schemas.microsoft.com/office/drawing/2014/main" id="{C904D63F-FE0D-EDB0-CA27-5FF75797F604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5799956" y="2103029"/>
                <a:ext cx="0" cy="271463"/>
              </a:xfrm>
              <a:custGeom>
                <a:avLst/>
                <a:gdLst>
                  <a:gd name="T0" fmla="*/ 0 h 53"/>
                  <a:gd name="T1" fmla="*/ 4 h 53"/>
                  <a:gd name="T2" fmla="*/ 8 h 53"/>
                  <a:gd name="T3" fmla="*/ 12 h 53"/>
                  <a:gd name="T4" fmla="*/ 16 h 53"/>
                  <a:gd name="T5" fmla="*/ 20 h 53"/>
                  <a:gd name="T6" fmla="*/ 24 h 53"/>
                  <a:gd name="T7" fmla="*/ 28 h 53"/>
                  <a:gd name="T8" fmla="*/ 32 h 53"/>
                  <a:gd name="T9" fmla="*/ 36 h 53"/>
                  <a:gd name="T10" fmla="*/ 40 h 53"/>
                  <a:gd name="T11" fmla="*/ 44 h 53"/>
                  <a:gd name="T12" fmla="*/ 48 h 53"/>
                  <a:gd name="T13" fmla="*/ 52 h 5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</a:cxnLst>
                <a:rect l="0" t="0" r="r" b="b"/>
                <a:pathLst>
                  <a:path h="53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9" name="Line 16">
                <a:extLst>
                  <a:ext uri="{FF2B5EF4-FFF2-40B4-BE49-F238E27FC236}">
                    <a16:creationId xmlns:a16="http://schemas.microsoft.com/office/drawing/2014/main" id="{BAAEEED1-AC71-C2CD-ED31-2D9928659E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9606" y="2960279"/>
                <a:ext cx="525463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0" name="Line 17">
                <a:extLst>
                  <a:ext uri="{FF2B5EF4-FFF2-40B4-BE49-F238E27FC236}">
                    <a16:creationId xmlns:a16="http://schemas.microsoft.com/office/drawing/2014/main" id="{2760DE6E-4247-EEDF-3EDF-C28F07F0AC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39606" y="2082391"/>
                <a:ext cx="525463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1" name="Rectangle 18">
                <a:extLst>
                  <a:ext uri="{FF2B5EF4-FFF2-40B4-BE49-F238E27FC236}">
                    <a16:creationId xmlns:a16="http://schemas.microsoft.com/office/drawing/2014/main" id="{8A8C85B6-6A0A-8662-0225-8BCA3875DA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79256" y="2374491"/>
                <a:ext cx="1046163" cy="295275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2" name="Line 19">
                <a:extLst>
                  <a:ext uri="{FF2B5EF4-FFF2-40B4-BE49-F238E27FC236}">
                    <a16:creationId xmlns:a16="http://schemas.microsoft.com/office/drawing/2014/main" id="{57C68D53-0154-D442-B1DE-9D8353607A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93443" y="3057116"/>
                <a:ext cx="1306513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" name="Line 20">
                <a:extLst>
                  <a:ext uri="{FF2B5EF4-FFF2-40B4-BE49-F238E27FC236}">
                    <a16:creationId xmlns:a16="http://schemas.microsoft.com/office/drawing/2014/main" id="{EDBF3096-4785-08E9-2972-31BC86A520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93443" y="3057116"/>
                <a:ext cx="0" cy="46038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" name="Line 21">
                <a:extLst>
                  <a:ext uri="{FF2B5EF4-FFF2-40B4-BE49-F238E27FC236}">
                    <a16:creationId xmlns:a16="http://schemas.microsoft.com/office/drawing/2014/main" id="{B8B9FE35-15CB-CA80-9420-F1B2CE8D34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99956" y="3057116"/>
                <a:ext cx="0" cy="46038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" name="Rectangle 22">
                <a:extLst>
                  <a:ext uri="{FF2B5EF4-FFF2-40B4-BE49-F238E27FC236}">
                    <a16:creationId xmlns:a16="http://schemas.microsoft.com/office/drawing/2014/main" id="{EE026DA5-DA4C-A6C6-A03E-C32ED7602B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88668" y="3160304"/>
                <a:ext cx="165281" cy="1192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n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Rectangle 23">
                <a:extLst>
                  <a:ext uri="{FF2B5EF4-FFF2-40B4-BE49-F238E27FC236}">
                    <a16:creationId xmlns:a16="http://schemas.microsoft.com/office/drawing/2014/main" id="{16D0FFB1-A609-A25D-86DD-2F28037CB6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26918" y="3160304"/>
                <a:ext cx="277640" cy="1192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omen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Line 24">
                <a:extLst>
                  <a:ext uri="{FF2B5EF4-FFF2-40B4-BE49-F238E27FC236}">
                    <a16:creationId xmlns:a16="http://schemas.microsoft.com/office/drawing/2014/main" id="{A67D29C3-A61C-CDF2-07A3-9F7932988C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33031" y="618716"/>
                <a:ext cx="0" cy="2341563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" name="Line 25">
                <a:extLst>
                  <a:ext uri="{FF2B5EF4-FFF2-40B4-BE49-F238E27FC236}">
                    <a16:creationId xmlns:a16="http://schemas.microsoft.com/office/drawing/2014/main" id="{16B81484-C25E-3D7C-CA7C-682F0E2E61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86993" y="2960279"/>
                <a:ext cx="46038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" name="Line 26">
                <a:extLst>
                  <a:ext uri="{FF2B5EF4-FFF2-40B4-BE49-F238E27FC236}">
                    <a16:creationId xmlns:a16="http://schemas.microsoft.com/office/drawing/2014/main" id="{DEBEA955-4765-5688-F58D-974183C80C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86993" y="2374491"/>
                <a:ext cx="46038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" name="Line 27">
                <a:extLst>
                  <a:ext uri="{FF2B5EF4-FFF2-40B4-BE49-F238E27FC236}">
                    <a16:creationId xmlns:a16="http://schemas.microsoft.com/office/drawing/2014/main" id="{D8EE161F-97F4-FB74-2C79-A899693E250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86993" y="1787116"/>
                <a:ext cx="46038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" name="Line 28">
                <a:extLst>
                  <a:ext uri="{FF2B5EF4-FFF2-40B4-BE49-F238E27FC236}">
                    <a16:creationId xmlns:a16="http://schemas.microsoft.com/office/drawing/2014/main" id="{99403AC9-3CCF-F21E-A6D7-FDCC86B4F3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86993" y="1204504"/>
                <a:ext cx="46038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" name="Line 29">
                <a:extLst>
                  <a:ext uri="{FF2B5EF4-FFF2-40B4-BE49-F238E27FC236}">
                    <a16:creationId xmlns:a16="http://schemas.microsoft.com/office/drawing/2014/main" id="{3AE244B0-E3CA-913E-29C0-0A2661E2CB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686993" y="618716"/>
                <a:ext cx="46038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" name="Rectangle 30">
                <a:extLst>
                  <a:ext uri="{FF2B5EF4-FFF2-40B4-BE49-F238E27FC236}">
                    <a16:creationId xmlns:a16="http://schemas.microsoft.com/office/drawing/2014/main" id="{9A38559B-A20E-5016-08F9-1D8FF11E90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2769" y="2925354"/>
                <a:ext cx="157258" cy="1192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8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Rectangle 31">
                <a:extLst>
                  <a:ext uri="{FF2B5EF4-FFF2-40B4-BE49-F238E27FC236}">
                    <a16:creationId xmlns:a16="http://schemas.microsoft.com/office/drawing/2014/main" id="{37CB33A0-EA72-15FB-0E94-FA3855139E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9961" y="2337979"/>
                <a:ext cx="157258" cy="1192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0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Rectangle 32">
                <a:extLst>
                  <a:ext uri="{FF2B5EF4-FFF2-40B4-BE49-F238E27FC236}">
                    <a16:creationId xmlns:a16="http://schemas.microsoft.com/office/drawing/2014/main" id="{2722EFF5-BE98-D578-A74A-378E223801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9961" y="1750604"/>
                <a:ext cx="157258" cy="1192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2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Rectangle 33">
                <a:extLst>
                  <a:ext uri="{FF2B5EF4-FFF2-40B4-BE49-F238E27FC236}">
                    <a16:creationId xmlns:a16="http://schemas.microsoft.com/office/drawing/2014/main" id="{210BD5E9-582D-2363-52AD-0BDF1437E0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52769" y="1164816"/>
                <a:ext cx="157258" cy="1192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4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Rectangle 34">
                <a:extLst>
                  <a:ext uri="{FF2B5EF4-FFF2-40B4-BE49-F238E27FC236}">
                    <a16:creationId xmlns:a16="http://schemas.microsoft.com/office/drawing/2014/main" id="{DE723220-A1FF-1830-3664-50F2535554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9961" y="577441"/>
                <a:ext cx="157258" cy="1192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6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Rectangle 35">
                <a:extLst>
                  <a:ext uri="{FF2B5EF4-FFF2-40B4-BE49-F238E27FC236}">
                    <a16:creationId xmlns:a16="http://schemas.microsoft.com/office/drawing/2014/main" id="{829CEA25-ED52-9DFA-AF70-FAB16ECAD1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3906" y="3231677"/>
                <a:ext cx="154048" cy="1362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x</a:t>
                </a:r>
                <a:endPara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Rectangle 36">
                <a:extLst>
                  <a:ext uri="{FF2B5EF4-FFF2-40B4-BE49-F238E27FC236}">
                    <a16:creationId xmlns:a16="http://schemas.microsoft.com/office/drawing/2014/main" id="{16E26F3B-832A-6350-8691-8C9A84C2F7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2729860" y="1745051"/>
                <a:ext cx="944543" cy="1303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Rs per 100,000</a:t>
                </a:r>
              </a:p>
            </p:txBody>
          </p:sp>
          <p:sp>
            <p:nvSpPr>
              <p:cNvPr id="40" name="Rectangle 37">
                <a:extLst>
                  <a:ext uri="{FF2B5EF4-FFF2-40B4-BE49-F238E27FC236}">
                    <a16:creationId xmlns:a16="http://schemas.microsoft.com/office/drawing/2014/main" id="{31E2D770-605C-4F9B-4A50-4C11947C1D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33031" y="521879"/>
                <a:ext cx="2827338" cy="2535238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3F91019C-1C97-E04D-ABD5-5118CEB2DF86}"/>
                </a:ext>
              </a:extLst>
            </p:cNvPr>
            <p:cNvSpPr txBox="1"/>
            <p:nvPr/>
          </p:nvSpPr>
          <p:spPr>
            <a:xfrm>
              <a:off x="5528334" y="858271"/>
              <a:ext cx="8696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kumimoji="1" lang="en-US" altLang="ja-JP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lt;0.05</a:t>
              </a:r>
              <a:endParaRPr kumimoji="1" lang="ja-JP" altLang="en-US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A3A4FD12-C1CE-2449-9474-DEEF49660031}"/>
                </a:ext>
              </a:extLst>
            </p:cNvPr>
            <p:cNvCxnSpPr>
              <a:cxnSpLocks/>
            </p:cNvCxnSpPr>
            <p:nvPr/>
          </p:nvCxnSpPr>
          <p:spPr>
            <a:xfrm>
              <a:off x="7264610" y="1281720"/>
              <a:ext cx="0" cy="273984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FF472BD8-5B0E-E9E3-AE03-BF45501E2463}"/>
                </a:ext>
              </a:extLst>
            </p:cNvPr>
            <p:cNvCxnSpPr>
              <a:cxnSpLocks/>
            </p:cNvCxnSpPr>
            <p:nvPr/>
          </p:nvCxnSpPr>
          <p:spPr>
            <a:xfrm>
              <a:off x="4796809" y="1271215"/>
              <a:ext cx="2467801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AB17BD8D-6D33-6B7B-1354-B718E4295951}"/>
                </a:ext>
              </a:extLst>
            </p:cNvPr>
            <p:cNvCxnSpPr>
              <a:cxnSpLocks/>
            </p:cNvCxnSpPr>
            <p:nvPr/>
          </p:nvCxnSpPr>
          <p:spPr>
            <a:xfrm>
              <a:off x="4796809" y="1271215"/>
              <a:ext cx="0" cy="467555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FE61A97-8216-6441-58F7-8C8FFCA9B59C}"/>
              </a:ext>
            </a:extLst>
          </p:cNvPr>
          <p:cNvSpPr txBox="1"/>
          <p:nvPr/>
        </p:nvSpPr>
        <p:spPr>
          <a:xfrm>
            <a:off x="199232" y="6133279"/>
            <a:ext cx="1189195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nual AAR data for men and women during the whole study period were compared by the Mann-Whitney U test. A statistically significant difference was observed (</a:t>
            </a:r>
            <a:r>
              <a:rPr lang="en-US" altLang="ja-JP" sz="16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0.0024).</a:t>
            </a:r>
            <a:endParaRPr lang="ja-JP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99471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E3126A0-1784-40DB-B89B-11AF89626DF8}"/>
              </a:ext>
            </a:extLst>
          </p:cNvPr>
          <p:cNvSpPr txBox="1"/>
          <p:nvPr/>
        </p:nvSpPr>
        <p:spPr>
          <a:xfrm>
            <a:off x="0" y="0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Supplementary Figure 3. Graphics of the </a:t>
            </a:r>
            <a:r>
              <a:rPr kumimoji="1" lang="en-US" altLang="ja-JP" sz="18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joinpoint</a:t>
            </a: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 regression model.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メイリオ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4076FD55-9618-5A10-5088-18FFE2A0C02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34" t="7992" r="26468" b="10657"/>
          <a:stretch/>
        </p:blipFill>
        <p:spPr>
          <a:xfrm>
            <a:off x="0" y="2041491"/>
            <a:ext cx="3975953" cy="324796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EF018A0-36BE-4B2E-B51F-36370A74695D}"/>
              </a:ext>
            </a:extLst>
          </p:cNvPr>
          <p:cNvSpPr txBox="1"/>
          <p:nvPr/>
        </p:nvSpPr>
        <p:spPr>
          <a:xfrm>
            <a:off x="1556002" y="1672158"/>
            <a:ext cx="1139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Total</a:t>
            </a:r>
            <a:endParaRPr kumimoji="1" lang="ja-JP" altLang="en-US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13E0D652-040A-1808-0099-463C59243EB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694" t="7934" r="27053" b="11366"/>
          <a:stretch/>
        </p:blipFill>
        <p:spPr>
          <a:xfrm>
            <a:off x="4045497" y="2041490"/>
            <a:ext cx="3965934" cy="324796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8006372-96B6-469D-9064-2E085E015ECF}"/>
              </a:ext>
            </a:extLst>
          </p:cNvPr>
          <p:cNvSpPr txBox="1"/>
          <p:nvPr/>
        </p:nvSpPr>
        <p:spPr>
          <a:xfrm>
            <a:off x="5802129" y="1672158"/>
            <a:ext cx="1139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/>
              <a:t>Men</a:t>
            </a:r>
            <a:endParaRPr kumimoji="1" lang="ja-JP" altLang="en-US" dirty="0"/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E92F0C39-1236-BD1A-EEF9-788204C09E1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709" t="8569" r="26755" b="11364"/>
          <a:stretch/>
        </p:blipFill>
        <p:spPr>
          <a:xfrm>
            <a:off x="8070003" y="2041490"/>
            <a:ext cx="3956506" cy="3247963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2429988-EE31-487D-944A-A1A8A172F09E}"/>
              </a:ext>
            </a:extLst>
          </p:cNvPr>
          <p:cNvSpPr txBox="1"/>
          <p:nvPr/>
        </p:nvSpPr>
        <p:spPr>
          <a:xfrm>
            <a:off x="9478514" y="1672158"/>
            <a:ext cx="11394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Women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349753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AA5C497-7D00-F79C-AFBF-C37624103821}"/>
              </a:ext>
            </a:extLst>
          </p:cNvPr>
          <p:cNvSpPr txBox="1"/>
          <p:nvPr/>
        </p:nvSpPr>
        <p:spPr>
          <a:xfrm>
            <a:off x="0" y="21357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メイリオ"/>
                <a:cs typeface="Times New Roman" panose="02020603050405020304" pitchFamily="18" charset="0"/>
              </a:rPr>
              <a:t>Supplementary Figure 4.</a:t>
            </a:r>
            <a:r>
              <a:rPr kumimoji="1" lang="en-US" altLang="ja-JP" b="1" dirty="0"/>
              <a:t> </a:t>
            </a:r>
            <a:r>
              <a:rPr lang="en-US" altLang="ja-JP" b="1" dirty="0"/>
              <a:t>Regional comparison of crude incidence rates of disseminated cryptococcosis among 70 years and older in Japan</a:t>
            </a:r>
            <a:endParaRPr kumimoji="1" lang="en-US" altLang="ja-JP" b="1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CEC4AC6A-DD37-FE66-ECEB-EEE8362F5337}"/>
              </a:ext>
            </a:extLst>
          </p:cNvPr>
          <p:cNvGrpSpPr/>
          <p:nvPr/>
        </p:nvGrpSpPr>
        <p:grpSpPr>
          <a:xfrm>
            <a:off x="2987340" y="521643"/>
            <a:ext cx="5554147" cy="5603263"/>
            <a:chOff x="2108542" y="864343"/>
            <a:chExt cx="5554147" cy="5603263"/>
          </a:xfrm>
        </p:grpSpPr>
        <p:grpSp>
          <p:nvGrpSpPr>
            <p:cNvPr id="118" name="グループ化 117">
              <a:extLst>
                <a:ext uri="{FF2B5EF4-FFF2-40B4-BE49-F238E27FC236}">
                  <a16:creationId xmlns:a16="http://schemas.microsoft.com/office/drawing/2014/main" id="{75168E99-BE67-BAC5-C01A-E6D4FE55E036}"/>
                </a:ext>
              </a:extLst>
            </p:cNvPr>
            <p:cNvGrpSpPr/>
            <p:nvPr/>
          </p:nvGrpSpPr>
          <p:grpSpPr>
            <a:xfrm>
              <a:off x="2108542" y="1834393"/>
              <a:ext cx="5554147" cy="4633213"/>
              <a:chOff x="2395858" y="547686"/>
              <a:chExt cx="6391142" cy="5423152"/>
            </a:xfrm>
          </p:grpSpPr>
          <p:grpSp>
            <p:nvGrpSpPr>
              <p:cNvPr id="114" name="グループ化 113">
                <a:extLst>
                  <a:ext uri="{FF2B5EF4-FFF2-40B4-BE49-F238E27FC236}">
                    <a16:creationId xmlns:a16="http://schemas.microsoft.com/office/drawing/2014/main" id="{A0224F17-F145-8A29-4CAF-426D1E6B21FF}"/>
                  </a:ext>
                </a:extLst>
              </p:cNvPr>
              <p:cNvGrpSpPr/>
              <p:nvPr/>
            </p:nvGrpSpPr>
            <p:grpSpPr>
              <a:xfrm>
                <a:off x="4964688" y="782020"/>
                <a:ext cx="993005" cy="1518025"/>
                <a:chOff x="3725094" y="779446"/>
                <a:chExt cx="993005" cy="1518025"/>
              </a:xfrm>
            </p:grpSpPr>
            <p:sp>
              <p:nvSpPr>
                <p:cNvPr id="61" name="Rectangle 59">
                  <a:extLst>
                    <a:ext uri="{FF2B5EF4-FFF2-40B4-BE49-F238E27FC236}">
                      <a16:creationId xmlns:a16="http://schemas.microsoft.com/office/drawing/2014/main" id="{8C67CCCB-5BF2-551D-5E13-3D675D0927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25094" y="1552943"/>
                  <a:ext cx="993005" cy="559121"/>
                </a:xfrm>
                <a:prstGeom prst="rect">
                  <a:avLst/>
                </a:prstGeom>
                <a:solidFill>
                  <a:srgbClr val="D3D3D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2" name="Line 60">
                  <a:extLst>
                    <a:ext uri="{FF2B5EF4-FFF2-40B4-BE49-F238E27FC236}">
                      <a16:creationId xmlns:a16="http://schemas.microsoft.com/office/drawing/2014/main" id="{B68766E5-20BA-7439-2A2A-C8F24C5E060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725094" y="1973008"/>
                  <a:ext cx="993005" cy="0"/>
                </a:xfrm>
                <a:prstGeom prst="line">
                  <a:avLst/>
                </a:prstGeom>
                <a:noFill/>
                <a:ln w="1587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3" name="Freeform 61">
                  <a:extLst>
                    <a:ext uri="{FF2B5EF4-FFF2-40B4-BE49-F238E27FC236}">
                      <a16:creationId xmlns:a16="http://schemas.microsoft.com/office/drawing/2014/main" id="{B4368D78-EF31-71DC-8FBE-CB9A75952E99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4221597" y="2112064"/>
                  <a:ext cx="0" cy="147748"/>
                </a:xfrm>
                <a:custGeom>
                  <a:avLst/>
                  <a:gdLst>
                    <a:gd name="T0" fmla="*/ 16 h 16"/>
                    <a:gd name="T1" fmla="*/ 12 h 16"/>
                    <a:gd name="T2" fmla="*/ 8 h 16"/>
                    <a:gd name="T3" fmla="*/ 4 h 1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</a:cxnLst>
                  <a:rect l="0" t="0" r="r" b="b"/>
                  <a:pathLst>
                    <a:path h="16">
                      <a:moveTo>
                        <a:pt x="0" y="12"/>
                      </a:moveTo>
                      <a:lnTo>
                        <a:pt x="0" y="8"/>
                      </a:lnTo>
                      <a:moveTo>
                        <a:pt x="0" y="4"/>
                      </a:moveTo>
                    </a:path>
                  </a:pathLst>
                </a:cu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4" name="Freeform 62">
                  <a:extLst>
                    <a:ext uri="{FF2B5EF4-FFF2-40B4-BE49-F238E27FC236}">
                      <a16:creationId xmlns:a16="http://schemas.microsoft.com/office/drawing/2014/main" id="{6516E774-E590-8665-9CD8-B1641E18F30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4221597" y="817106"/>
                  <a:ext cx="0" cy="735837"/>
                </a:xfrm>
                <a:custGeom>
                  <a:avLst/>
                  <a:gdLst>
                    <a:gd name="T0" fmla="*/ 0 h 79"/>
                    <a:gd name="T1" fmla="*/ 4 h 79"/>
                    <a:gd name="T2" fmla="*/ 8 h 79"/>
                    <a:gd name="T3" fmla="*/ 12 h 79"/>
                    <a:gd name="T4" fmla="*/ 16 h 79"/>
                    <a:gd name="T5" fmla="*/ 20 h 79"/>
                    <a:gd name="T6" fmla="*/ 24 h 79"/>
                    <a:gd name="T7" fmla="*/ 28 h 79"/>
                    <a:gd name="T8" fmla="*/ 32 h 79"/>
                    <a:gd name="T9" fmla="*/ 36 h 79"/>
                    <a:gd name="T10" fmla="*/ 40 h 79"/>
                    <a:gd name="T11" fmla="*/ 44 h 79"/>
                    <a:gd name="T12" fmla="*/ 48 h 79"/>
                    <a:gd name="T13" fmla="*/ 52 h 79"/>
                    <a:gd name="T14" fmla="*/ 56 h 79"/>
                    <a:gd name="T15" fmla="*/ 60 h 79"/>
                    <a:gd name="T16" fmla="*/ 64 h 79"/>
                    <a:gd name="T17" fmla="*/ 68 h 79"/>
                    <a:gd name="T18" fmla="*/ 72 h 79"/>
                    <a:gd name="T19" fmla="*/ 76 h 7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  <a:cxn ang="0">
                      <a:pos x="0" y="T12"/>
                    </a:cxn>
                    <a:cxn ang="0">
                      <a:pos x="0" y="T13"/>
                    </a:cxn>
                    <a:cxn ang="0">
                      <a:pos x="0" y="T14"/>
                    </a:cxn>
                    <a:cxn ang="0">
                      <a:pos x="0" y="T15"/>
                    </a:cxn>
                    <a:cxn ang="0">
                      <a:pos x="0" y="T16"/>
                    </a:cxn>
                    <a:cxn ang="0">
                      <a:pos x="0" y="T17"/>
                    </a:cxn>
                    <a:cxn ang="0">
                      <a:pos x="0" y="T18"/>
                    </a:cxn>
                    <a:cxn ang="0">
                      <a:pos x="0" y="T19"/>
                    </a:cxn>
                  </a:cxnLst>
                  <a:rect l="0" t="0" r="r" b="b"/>
                  <a:pathLst>
                    <a:path h="79">
                      <a:moveTo>
                        <a:pt x="0" y="4"/>
                      </a:moveTo>
                      <a:lnTo>
                        <a:pt x="0" y="8"/>
                      </a:lnTo>
                      <a:moveTo>
                        <a:pt x="0" y="12"/>
                      </a:moveTo>
                      <a:lnTo>
                        <a:pt x="0" y="16"/>
                      </a:lnTo>
                      <a:moveTo>
                        <a:pt x="0" y="20"/>
                      </a:moveTo>
                      <a:lnTo>
                        <a:pt x="0" y="24"/>
                      </a:lnTo>
                      <a:moveTo>
                        <a:pt x="0" y="28"/>
                      </a:moveTo>
                      <a:lnTo>
                        <a:pt x="0" y="32"/>
                      </a:lnTo>
                      <a:moveTo>
                        <a:pt x="0" y="36"/>
                      </a:moveTo>
                      <a:lnTo>
                        <a:pt x="0" y="40"/>
                      </a:lnTo>
                      <a:moveTo>
                        <a:pt x="0" y="44"/>
                      </a:moveTo>
                      <a:lnTo>
                        <a:pt x="0" y="48"/>
                      </a:lnTo>
                      <a:moveTo>
                        <a:pt x="0" y="52"/>
                      </a:moveTo>
                      <a:lnTo>
                        <a:pt x="0" y="56"/>
                      </a:lnTo>
                      <a:moveTo>
                        <a:pt x="0" y="60"/>
                      </a:moveTo>
                      <a:lnTo>
                        <a:pt x="0" y="64"/>
                      </a:lnTo>
                      <a:moveTo>
                        <a:pt x="0" y="68"/>
                      </a:moveTo>
                      <a:lnTo>
                        <a:pt x="0" y="72"/>
                      </a:lnTo>
                      <a:moveTo>
                        <a:pt x="0" y="76"/>
                      </a:moveTo>
                    </a:path>
                  </a:pathLst>
                </a:cu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5" name="Line 63">
                  <a:extLst>
                    <a:ext uri="{FF2B5EF4-FFF2-40B4-BE49-F238E27FC236}">
                      <a16:creationId xmlns:a16="http://schemas.microsoft.com/office/drawing/2014/main" id="{B3C1A2D8-6A17-068C-798B-18EBDFDE56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67291" y="2297471"/>
                  <a:ext cx="49650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6" name="Line 64">
                  <a:extLst>
                    <a:ext uri="{FF2B5EF4-FFF2-40B4-BE49-F238E27FC236}">
                      <a16:creationId xmlns:a16="http://schemas.microsoft.com/office/drawing/2014/main" id="{B7FB8D96-FF45-B0C8-30BD-A5D1676A620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3967291" y="779446"/>
                  <a:ext cx="496503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" name="Rectangle 65">
                  <a:extLst>
                    <a:ext uri="{FF2B5EF4-FFF2-40B4-BE49-F238E27FC236}">
                      <a16:creationId xmlns:a16="http://schemas.microsoft.com/office/drawing/2014/main" id="{EC105E59-02EB-264B-D832-0CE4EBE5A27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725094" y="1552943"/>
                  <a:ext cx="993005" cy="559121"/>
                </a:xfrm>
                <a:prstGeom prst="rect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113" name="グループ化 112">
                <a:extLst>
                  <a:ext uri="{FF2B5EF4-FFF2-40B4-BE49-F238E27FC236}">
                    <a16:creationId xmlns:a16="http://schemas.microsoft.com/office/drawing/2014/main" id="{BE58C297-8467-E972-33CA-3D09ABED5FCC}"/>
                  </a:ext>
                </a:extLst>
              </p:cNvPr>
              <p:cNvGrpSpPr/>
              <p:nvPr/>
            </p:nvGrpSpPr>
            <p:grpSpPr>
              <a:xfrm>
                <a:off x="3733545" y="3050690"/>
                <a:ext cx="989979" cy="1946781"/>
                <a:chOff x="4972406" y="3050690"/>
                <a:chExt cx="989979" cy="1946781"/>
              </a:xfrm>
            </p:grpSpPr>
            <p:sp>
              <p:nvSpPr>
                <p:cNvPr id="68" name="Rectangle 66">
                  <a:extLst>
                    <a:ext uri="{FF2B5EF4-FFF2-40B4-BE49-F238E27FC236}">
                      <a16:creationId xmlns:a16="http://schemas.microsoft.com/office/drawing/2014/main" id="{BD96514E-BFE7-4CC4-5515-A23B2975DFC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72406" y="3517106"/>
                  <a:ext cx="989979" cy="689485"/>
                </a:xfrm>
                <a:prstGeom prst="rect">
                  <a:avLst/>
                </a:prstGeom>
                <a:solidFill>
                  <a:srgbClr val="D3D3D3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dirty="0"/>
                </a:p>
              </p:txBody>
            </p:sp>
            <p:sp>
              <p:nvSpPr>
                <p:cNvPr id="69" name="Line 67">
                  <a:extLst>
                    <a:ext uri="{FF2B5EF4-FFF2-40B4-BE49-F238E27FC236}">
                      <a16:creationId xmlns:a16="http://schemas.microsoft.com/office/drawing/2014/main" id="{EFB9D48F-DAB3-F576-515F-322D28ADF8D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72406" y="3769145"/>
                  <a:ext cx="989979" cy="0"/>
                </a:xfrm>
                <a:prstGeom prst="line">
                  <a:avLst/>
                </a:prstGeom>
                <a:noFill/>
                <a:ln w="1587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0" name="Freeform 68">
                  <a:extLst>
                    <a:ext uri="{FF2B5EF4-FFF2-40B4-BE49-F238E27FC236}">
                      <a16:creationId xmlns:a16="http://schemas.microsoft.com/office/drawing/2014/main" id="{6647728B-C156-5B34-BFEB-37EBF1C2F46B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5465882" y="4206591"/>
                  <a:ext cx="0" cy="753219"/>
                </a:xfrm>
                <a:custGeom>
                  <a:avLst/>
                  <a:gdLst>
                    <a:gd name="T0" fmla="*/ 81 h 81"/>
                    <a:gd name="T1" fmla="*/ 77 h 81"/>
                    <a:gd name="T2" fmla="*/ 73 h 81"/>
                    <a:gd name="T3" fmla="*/ 69 h 81"/>
                    <a:gd name="T4" fmla="*/ 65 h 81"/>
                    <a:gd name="T5" fmla="*/ 61 h 81"/>
                    <a:gd name="T6" fmla="*/ 57 h 81"/>
                    <a:gd name="T7" fmla="*/ 53 h 81"/>
                    <a:gd name="T8" fmla="*/ 49 h 81"/>
                    <a:gd name="T9" fmla="*/ 45 h 81"/>
                    <a:gd name="T10" fmla="*/ 41 h 81"/>
                    <a:gd name="T11" fmla="*/ 37 h 81"/>
                    <a:gd name="T12" fmla="*/ 33 h 81"/>
                    <a:gd name="T13" fmla="*/ 29 h 81"/>
                    <a:gd name="T14" fmla="*/ 25 h 81"/>
                    <a:gd name="T15" fmla="*/ 21 h 81"/>
                    <a:gd name="T16" fmla="*/ 17 h 81"/>
                    <a:gd name="T17" fmla="*/ 13 h 81"/>
                    <a:gd name="T18" fmla="*/ 9 h 81"/>
                    <a:gd name="T19" fmla="*/ 5 h 81"/>
                    <a:gd name="T20" fmla="*/ 1 h 81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  <a:cxn ang="0">
                      <a:pos x="0" y="T12"/>
                    </a:cxn>
                    <a:cxn ang="0">
                      <a:pos x="0" y="T13"/>
                    </a:cxn>
                    <a:cxn ang="0">
                      <a:pos x="0" y="T14"/>
                    </a:cxn>
                    <a:cxn ang="0">
                      <a:pos x="0" y="T15"/>
                    </a:cxn>
                    <a:cxn ang="0">
                      <a:pos x="0" y="T16"/>
                    </a:cxn>
                    <a:cxn ang="0">
                      <a:pos x="0" y="T17"/>
                    </a:cxn>
                    <a:cxn ang="0">
                      <a:pos x="0" y="T18"/>
                    </a:cxn>
                    <a:cxn ang="0">
                      <a:pos x="0" y="T19"/>
                    </a:cxn>
                    <a:cxn ang="0">
                      <a:pos x="0" y="T20"/>
                    </a:cxn>
                  </a:cxnLst>
                  <a:rect l="0" t="0" r="r" b="b"/>
                  <a:pathLst>
                    <a:path h="81">
                      <a:moveTo>
                        <a:pt x="0" y="77"/>
                      </a:moveTo>
                      <a:lnTo>
                        <a:pt x="0" y="73"/>
                      </a:lnTo>
                      <a:moveTo>
                        <a:pt x="0" y="69"/>
                      </a:moveTo>
                      <a:lnTo>
                        <a:pt x="0" y="65"/>
                      </a:lnTo>
                      <a:moveTo>
                        <a:pt x="0" y="61"/>
                      </a:moveTo>
                      <a:lnTo>
                        <a:pt x="0" y="57"/>
                      </a:lnTo>
                      <a:moveTo>
                        <a:pt x="0" y="53"/>
                      </a:moveTo>
                      <a:lnTo>
                        <a:pt x="0" y="49"/>
                      </a:lnTo>
                      <a:moveTo>
                        <a:pt x="0" y="45"/>
                      </a:moveTo>
                      <a:lnTo>
                        <a:pt x="0" y="41"/>
                      </a:lnTo>
                      <a:moveTo>
                        <a:pt x="0" y="37"/>
                      </a:moveTo>
                      <a:lnTo>
                        <a:pt x="0" y="33"/>
                      </a:lnTo>
                      <a:moveTo>
                        <a:pt x="0" y="29"/>
                      </a:moveTo>
                      <a:lnTo>
                        <a:pt x="0" y="25"/>
                      </a:lnTo>
                      <a:moveTo>
                        <a:pt x="0" y="21"/>
                      </a:moveTo>
                      <a:lnTo>
                        <a:pt x="0" y="17"/>
                      </a:lnTo>
                      <a:moveTo>
                        <a:pt x="0" y="13"/>
                      </a:moveTo>
                      <a:lnTo>
                        <a:pt x="0" y="9"/>
                      </a:lnTo>
                      <a:moveTo>
                        <a:pt x="0" y="5"/>
                      </a:moveTo>
                      <a:lnTo>
                        <a:pt x="0" y="1"/>
                      </a:lnTo>
                    </a:path>
                  </a:pathLst>
                </a:cu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1" name="Freeform 69">
                  <a:extLst>
                    <a:ext uri="{FF2B5EF4-FFF2-40B4-BE49-F238E27FC236}">
                      <a16:creationId xmlns:a16="http://schemas.microsoft.com/office/drawing/2014/main" id="{545B6D1C-DF6B-1892-8831-B42E08F8C376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5465882" y="3088350"/>
                  <a:ext cx="0" cy="428755"/>
                </a:xfrm>
                <a:custGeom>
                  <a:avLst/>
                  <a:gdLst>
                    <a:gd name="T0" fmla="*/ 0 h 46"/>
                    <a:gd name="T1" fmla="*/ 4 h 46"/>
                    <a:gd name="T2" fmla="*/ 8 h 46"/>
                    <a:gd name="T3" fmla="*/ 12 h 46"/>
                    <a:gd name="T4" fmla="*/ 16 h 46"/>
                    <a:gd name="T5" fmla="*/ 20 h 46"/>
                    <a:gd name="T6" fmla="*/ 24 h 46"/>
                    <a:gd name="T7" fmla="*/ 28 h 46"/>
                    <a:gd name="T8" fmla="*/ 32 h 46"/>
                    <a:gd name="T9" fmla="*/ 36 h 46"/>
                    <a:gd name="T10" fmla="*/ 40 h 46"/>
                    <a:gd name="T11" fmla="*/ 44 h 46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  <a:cxn ang="0">
                      <a:pos x="0" y="T3"/>
                    </a:cxn>
                    <a:cxn ang="0">
                      <a:pos x="0" y="T4"/>
                    </a:cxn>
                    <a:cxn ang="0">
                      <a:pos x="0" y="T5"/>
                    </a:cxn>
                    <a:cxn ang="0">
                      <a:pos x="0" y="T6"/>
                    </a:cxn>
                    <a:cxn ang="0">
                      <a:pos x="0" y="T7"/>
                    </a:cxn>
                    <a:cxn ang="0">
                      <a:pos x="0" y="T8"/>
                    </a:cxn>
                    <a:cxn ang="0">
                      <a:pos x="0" y="T9"/>
                    </a:cxn>
                    <a:cxn ang="0">
                      <a:pos x="0" y="T10"/>
                    </a:cxn>
                    <a:cxn ang="0">
                      <a:pos x="0" y="T11"/>
                    </a:cxn>
                  </a:cxnLst>
                  <a:rect l="0" t="0" r="r" b="b"/>
                  <a:pathLst>
                    <a:path h="46">
                      <a:moveTo>
                        <a:pt x="0" y="4"/>
                      </a:moveTo>
                      <a:lnTo>
                        <a:pt x="0" y="8"/>
                      </a:lnTo>
                      <a:moveTo>
                        <a:pt x="0" y="12"/>
                      </a:moveTo>
                      <a:lnTo>
                        <a:pt x="0" y="16"/>
                      </a:lnTo>
                      <a:moveTo>
                        <a:pt x="0" y="20"/>
                      </a:moveTo>
                      <a:lnTo>
                        <a:pt x="0" y="24"/>
                      </a:lnTo>
                      <a:moveTo>
                        <a:pt x="0" y="28"/>
                      </a:moveTo>
                      <a:lnTo>
                        <a:pt x="0" y="32"/>
                      </a:lnTo>
                      <a:moveTo>
                        <a:pt x="0" y="36"/>
                      </a:moveTo>
                      <a:lnTo>
                        <a:pt x="0" y="40"/>
                      </a:lnTo>
                      <a:moveTo>
                        <a:pt x="0" y="44"/>
                      </a:moveTo>
                    </a:path>
                  </a:pathLst>
                </a:cu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2" name="Line 70">
                  <a:extLst>
                    <a:ext uri="{FF2B5EF4-FFF2-40B4-BE49-F238E27FC236}">
                      <a16:creationId xmlns:a16="http://schemas.microsoft.com/office/drawing/2014/main" id="{0A74ED3D-82E3-2A0D-F203-662DC1CF9D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14602" y="4997471"/>
                  <a:ext cx="505586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3" name="Line 71">
                  <a:extLst>
                    <a:ext uri="{FF2B5EF4-FFF2-40B4-BE49-F238E27FC236}">
                      <a16:creationId xmlns:a16="http://schemas.microsoft.com/office/drawing/2014/main" id="{E7DA4134-6137-0A67-5B17-0A37012C6DD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14602" y="3050690"/>
                  <a:ext cx="505586" cy="0"/>
                </a:xfrm>
                <a:prstGeom prst="line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74" name="Rectangle 72">
                  <a:extLst>
                    <a:ext uri="{FF2B5EF4-FFF2-40B4-BE49-F238E27FC236}">
                      <a16:creationId xmlns:a16="http://schemas.microsoft.com/office/drawing/2014/main" id="{8389A005-84EE-B4C1-1EDE-AD27A6616AC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72406" y="3517106"/>
                  <a:ext cx="989979" cy="689485"/>
                </a:xfrm>
                <a:prstGeom prst="rect">
                  <a:avLst/>
                </a:prstGeom>
                <a:noFill/>
                <a:ln w="4763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75" name="Rectangle 73">
                <a:extLst>
                  <a:ext uri="{FF2B5EF4-FFF2-40B4-BE49-F238E27FC236}">
                    <a16:creationId xmlns:a16="http://schemas.microsoft.com/office/drawing/2014/main" id="{B0360416-DDC4-0B52-C8AB-8206C751C6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16690" y="1283523"/>
                <a:ext cx="1002088" cy="761911"/>
              </a:xfrm>
              <a:prstGeom prst="rect">
                <a:avLst/>
              </a:prstGeom>
              <a:solidFill>
                <a:srgbClr val="D3D3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6" name="Line 74">
                <a:extLst>
                  <a:ext uri="{FF2B5EF4-FFF2-40B4-BE49-F238E27FC236}">
                    <a16:creationId xmlns:a16="http://schemas.microsoft.com/office/drawing/2014/main" id="{BE235E5B-4F70-C0FC-2A0E-CD55FCB144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16690" y="1590604"/>
                <a:ext cx="1002088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7" name="Freeform 75">
                <a:extLst>
                  <a:ext uri="{FF2B5EF4-FFF2-40B4-BE49-F238E27FC236}">
                    <a16:creationId xmlns:a16="http://schemas.microsoft.com/office/drawing/2014/main" id="{D6D9EF2F-8CE3-2B9C-D4F4-7745F651E41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13193" y="2045432"/>
                <a:ext cx="0" cy="727147"/>
              </a:xfrm>
              <a:custGeom>
                <a:avLst/>
                <a:gdLst>
                  <a:gd name="T0" fmla="*/ 78 h 78"/>
                  <a:gd name="T1" fmla="*/ 74 h 78"/>
                  <a:gd name="T2" fmla="*/ 70 h 78"/>
                  <a:gd name="T3" fmla="*/ 66 h 78"/>
                  <a:gd name="T4" fmla="*/ 62 h 78"/>
                  <a:gd name="T5" fmla="*/ 58 h 78"/>
                  <a:gd name="T6" fmla="*/ 54 h 78"/>
                  <a:gd name="T7" fmla="*/ 50 h 78"/>
                  <a:gd name="T8" fmla="*/ 46 h 78"/>
                  <a:gd name="T9" fmla="*/ 42 h 78"/>
                  <a:gd name="T10" fmla="*/ 38 h 78"/>
                  <a:gd name="T11" fmla="*/ 34 h 78"/>
                  <a:gd name="T12" fmla="*/ 30 h 78"/>
                  <a:gd name="T13" fmla="*/ 26 h 78"/>
                  <a:gd name="T14" fmla="*/ 22 h 78"/>
                  <a:gd name="T15" fmla="*/ 18 h 78"/>
                  <a:gd name="T16" fmla="*/ 14 h 78"/>
                  <a:gd name="T17" fmla="*/ 10 h 78"/>
                  <a:gd name="T18" fmla="*/ 6 h 78"/>
                  <a:gd name="T19" fmla="*/ 2 h 7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</a:cxnLst>
                <a:rect l="0" t="0" r="r" b="b"/>
                <a:pathLst>
                  <a:path h="78">
                    <a:moveTo>
                      <a:pt x="0" y="74"/>
                    </a:moveTo>
                    <a:lnTo>
                      <a:pt x="0" y="70"/>
                    </a:lnTo>
                    <a:moveTo>
                      <a:pt x="0" y="66"/>
                    </a:moveTo>
                    <a:lnTo>
                      <a:pt x="0" y="62"/>
                    </a:lnTo>
                    <a:moveTo>
                      <a:pt x="0" y="58"/>
                    </a:moveTo>
                    <a:lnTo>
                      <a:pt x="0" y="54"/>
                    </a:lnTo>
                    <a:moveTo>
                      <a:pt x="0" y="50"/>
                    </a:moveTo>
                    <a:lnTo>
                      <a:pt x="0" y="46"/>
                    </a:lnTo>
                    <a:moveTo>
                      <a:pt x="0" y="42"/>
                    </a:moveTo>
                    <a:lnTo>
                      <a:pt x="0" y="38"/>
                    </a:lnTo>
                    <a:moveTo>
                      <a:pt x="0" y="34"/>
                    </a:moveTo>
                    <a:lnTo>
                      <a:pt x="0" y="30"/>
                    </a:lnTo>
                    <a:moveTo>
                      <a:pt x="0" y="26"/>
                    </a:moveTo>
                    <a:lnTo>
                      <a:pt x="0" y="22"/>
                    </a:lnTo>
                    <a:moveTo>
                      <a:pt x="0" y="18"/>
                    </a:moveTo>
                    <a:lnTo>
                      <a:pt x="0" y="14"/>
                    </a:lnTo>
                    <a:moveTo>
                      <a:pt x="0" y="10"/>
                    </a:moveTo>
                    <a:lnTo>
                      <a:pt x="0" y="6"/>
                    </a:lnTo>
                    <a:moveTo>
                      <a:pt x="0" y="2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8" name="Freeform 76">
                <a:extLst>
                  <a:ext uri="{FF2B5EF4-FFF2-40B4-BE49-F238E27FC236}">
                    <a16:creationId xmlns:a16="http://schemas.microsoft.com/office/drawing/2014/main" id="{7AFA4CCB-CCC6-C877-9854-C70F6E8FF39B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6713193" y="1011205"/>
                <a:ext cx="0" cy="272318"/>
              </a:xfrm>
              <a:custGeom>
                <a:avLst/>
                <a:gdLst>
                  <a:gd name="T0" fmla="*/ 0 h 29"/>
                  <a:gd name="T1" fmla="*/ 4 h 29"/>
                  <a:gd name="T2" fmla="*/ 8 h 29"/>
                  <a:gd name="T3" fmla="*/ 12 h 29"/>
                  <a:gd name="T4" fmla="*/ 16 h 29"/>
                  <a:gd name="T5" fmla="*/ 20 h 29"/>
                  <a:gd name="T6" fmla="*/ 24 h 29"/>
                  <a:gd name="T7" fmla="*/ 28 h 2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</a:cxnLst>
                <a:rect l="0" t="0" r="r" b="b"/>
                <a:pathLst>
                  <a:path h="2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79" name="Line 77">
                <a:extLst>
                  <a:ext uri="{FF2B5EF4-FFF2-40B4-BE49-F238E27FC236}">
                    <a16:creationId xmlns:a16="http://schemas.microsoft.com/office/drawing/2014/main" id="{2C2D542B-71BB-D8EA-8518-27BBA797AB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70996" y="2810239"/>
                <a:ext cx="493476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0" name="Line 78">
                <a:extLst>
                  <a:ext uri="{FF2B5EF4-FFF2-40B4-BE49-F238E27FC236}">
                    <a16:creationId xmlns:a16="http://schemas.microsoft.com/office/drawing/2014/main" id="{ECA98095-216C-8FCD-34C8-97D94CC440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70996" y="976441"/>
                <a:ext cx="493476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1" name="Rectangle 79">
                <a:extLst>
                  <a:ext uri="{FF2B5EF4-FFF2-40B4-BE49-F238E27FC236}">
                    <a16:creationId xmlns:a16="http://schemas.microsoft.com/office/drawing/2014/main" id="{86105BD9-45B7-90F2-7AE4-D9741F47E4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16690" y="1283523"/>
                <a:ext cx="1002088" cy="761911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2" name="Rectangle 80">
                <a:extLst>
                  <a:ext uri="{FF2B5EF4-FFF2-40B4-BE49-F238E27FC236}">
                    <a16:creationId xmlns:a16="http://schemas.microsoft.com/office/drawing/2014/main" id="{A585D5E8-3770-E85F-BE06-9E5A9E30C8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60973" y="1712278"/>
                <a:ext cx="1005115" cy="1161696"/>
              </a:xfrm>
              <a:prstGeom prst="rect">
                <a:avLst/>
              </a:prstGeom>
              <a:solidFill>
                <a:srgbClr val="D3D3D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3" name="Line 81">
                <a:extLst>
                  <a:ext uri="{FF2B5EF4-FFF2-40B4-BE49-F238E27FC236}">
                    <a16:creationId xmlns:a16="http://schemas.microsoft.com/office/drawing/2014/main" id="{D02C4823-A419-AB47-5879-6DD0997990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60973" y="2445217"/>
                <a:ext cx="1005115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4" name="Freeform 82">
                <a:extLst>
                  <a:ext uri="{FF2B5EF4-FFF2-40B4-BE49-F238E27FC236}">
                    <a16:creationId xmlns:a16="http://schemas.microsoft.com/office/drawing/2014/main" id="{4FBFDE5C-715E-5126-2C12-65BB4033F33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969585" y="2873973"/>
                <a:ext cx="0" cy="214378"/>
              </a:xfrm>
              <a:custGeom>
                <a:avLst/>
                <a:gdLst>
                  <a:gd name="T0" fmla="*/ 23 h 23"/>
                  <a:gd name="T1" fmla="*/ 19 h 23"/>
                  <a:gd name="T2" fmla="*/ 15 h 23"/>
                  <a:gd name="T3" fmla="*/ 11 h 23"/>
                  <a:gd name="T4" fmla="*/ 7 h 23"/>
                  <a:gd name="T5" fmla="*/ 3 h 2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3"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5" name="Freeform 83">
                <a:extLst>
                  <a:ext uri="{FF2B5EF4-FFF2-40B4-BE49-F238E27FC236}">
                    <a16:creationId xmlns:a16="http://schemas.microsoft.com/office/drawing/2014/main" id="{34676B52-CE7D-9685-4DB3-BFD9EB598EF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7969585" y="762064"/>
                <a:ext cx="0" cy="950215"/>
              </a:xfrm>
              <a:custGeom>
                <a:avLst/>
                <a:gdLst>
                  <a:gd name="T0" fmla="*/ 0 h 102"/>
                  <a:gd name="T1" fmla="*/ 4 h 102"/>
                  <a:gd name="T2" fmla="*/ 8 h 102"/>
                  <a:gd name="T3" fmla="*/ 12 h 102"/>
                  <a:gd name="T4" fmla="*/ 16 h 102"/>
                  <a:gd name="T5" fmla="*/ 20 h 102"/>
                  <a:gd name="T6" fmla="*/ 24 h 102"/>
                  <a:gd name="T7" fmla="*/ 28 h 102"/>
                  <a:gd name="T8" fmla="*/ 32 h 102"/>
                  <a:gd name="T9" fmla="*/ 36 h 102"/>
                  <a:gd name="T10" fmla="*/ 40 h 102"/>
                  <a:gd name="T11" fmla="*/ 44 h 102"/>
                  <a:gd name="T12" fmla="*/ 48 h 102"/>
                  <a:gd name="T13" fmla="*/ 52 h 102"/>
                  <a:gd name="T14" fmla="*/ 56 h 102"/>
                  <a:gd name="T15" fmla="*/ 60 h 102"/>
                  <a:gd name="T16" fmla="*/ 64 h 102"/>
                  <a:gd name="T17" fmla="*/ 68 h 102"/>
                  <a:gd name="T18" fmla="*/ 72 h 102"/>
                  <a:gd name="T19" fmla="*/ 76 h 102"/>
                  <a:gd name="T20" fmla="*/ 80 h 102"/>
                  <a:gd name="T21" fmla="*/ 84 h 102"/>
                  <a:gd name="T22" fmla="*/ 88 h 102"/>
                  <a:gd name="T23" fmla="*/ 92 h 102"/>
                  <a:gd name="T24" fmla="*/ 96 h 102"/>
                  <a:gd name="T25" fmla="*/ 100 h 102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</a:cxnLst>
                <a:rect l="0" t="0" r="r" b="b"/>
                <a:pathLst>
                  <a:path h="102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  <a:moveTo>
                      <a:pt x="0" y="100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6" name="Line 84">
                <a:extLst>
                  <a:ext uri="{FF2B5EF4-FFF2-40B4-BE49-F238E27FC236}">
                    <a16:creationId xmlns:a16="http://schemas.microsoft.com/office/drawing/2014/main" id="{1AA8926C-F62E-62CE-9361-C181D9D6F9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15279" y="3126012"/>
                <a:ext cx="496503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7" name="Line 85">
                <a:extLst>
                  <a:ext uri="{FF2B5EF4-FFF2-40B4-BE49-F238E27FC236}">
                    <a16:creationId xmlns:a16="http://schemas.microsoft.com/office/drawing/2014/main" id="{3AA34A96-2868-3BAF-F812-B0332AB1C8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715279" y="724402"/>
                <a:ext cx="496503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8" name="Rectangle 86">
                <a:extLst>
                  <a:ext uri="{FF2B5EF4-FFF2-40B4-BE49-F238E27FC236}">
                    <a16:creationId xmlns:a16="http://schemas.microsoft.com/office/drawing/2014/main" id="{11BE39C1-DD2E-C6C0-A935-48FD10FF84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60973" y="1712278"/>
                <a:ext cx="1005115" cy="1161696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89" name="Line 87">
                <a:extLst>
                  <a:ext uri="{FF2B5EF4-FFF2-40B4-BE49-F238E27FC236}">
                    <a16:creationId xmlns:a16="http://schemas.microsoft.com/office/drawing/2014/main" id="{59251864-1794-0152-0D43-9BDA1A1917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1597" y="5174187"/>
                <a:ext cx="3747989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0" name="Line 88">
                <a:extLst>
                  <a:ext uri="{FF2B5EF4-FFF2-40B4-BE49-F238E27FC236}">
                    <a16:creationId xmlns:a16="http://schemas.microsoft.com/office/drawing/2014/main" id="{EB389B72-B195-4119-1E7B-6E4B06F716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1597" y="5174187"/>
                <a:ext cx="0" cy="84014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1" name="Line 89">
                <a:extLst>
                  <a:ext uri="{FF2B5EF4-FFF2-40B4-BE49-F238E27FC236}">
                    <a16:creationId xmlns:a16="http://schemas.microsoft.com/office/drawing/2014/main" id="{5FA004EE-2A27-8998-609A-9131C9C905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65882" y="5174187"/>
                <a:ext cx="0" cy="84014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2" name="Line 90">
                <a:extLst>
                  <a:ext uri="{FF2B5EF4-FFF2-40B4-BE49-F238E27FC236}">
                    <a16:creationId xmlns:a16="http://schemas.microsoft.com/office/drawing/2014/main" id="{EE2A54E7-4D15-82DB-58CA-152A02EFFB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13193" y="5174187"/>
                <a:ext cx="0" cy="84014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3" name="Line 91">
                <a:extLst>
                  <a:ext uri="{FF2B5EF4-FFF2-40B4-BE49-F238E27FC236}">
                    <a16:creationId xmlns:a16="http://schemas.microsoft.com/office/drawing/2014/main" id="{CA8774CC-E1C6-B9DE-E9DC-BD4B205A7B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69585" y="5174187"/>
                <a:ext cx="0" cy="84014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4" name="Rectangle 92">
                <a:extLst>
                  <a:ext uri="{FF2B5EF4-FFF2-40B4-BE49-F238E27FC236}">
                    <a16:creationId xmlns:a16="http://schemas.microsoft.com/office/drawing/2014/main" id="{0604C7CF-440A-924C-6F8D-4688005AB3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70703" y="5362493"/>
                <a:ext cx="99386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Eastern Japan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5" name="Rectangle 93">
                <a:extLst>
                  <a:ext uri="{FF2B5EF4-FFF2-40B4-BE49-F238E27FC236}">
                    <a16:creationId xmlns:a16="http://schemas.microsoft.com/office/drawing/2014/main" id="{86E1B2DF-349E-92B3-EFC0-270FA23FE4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73326" y="5362493"/>
                <a:ext cx="110286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Northern Japan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6" name="Rectangle 94">
                <a:extLst>
                  <a:ext uri="{FF2B5EF4-FFF2-40B4-BE49-F238E27FC236}">
                    <a16:creationId xmlns:a16="http://schemas.microsoft.com/office/drawing/2014/main" id="{84B13E51-2786-3A62-381A-EDFCBA19FE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64026" y="5362493"/>
                <a:ext cx="110286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Southern Japan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7" name="Rectangle 95">
                <a:extLst>
                  <a:ext uri="{FF2B5EF4-FFF2-40B4-BE49-F238E27FC236}">
                    <a16:creationId xmlns:a16="http://schemas.microsoft.com/office/drawing/2014/main" id="{772F4760-75B0-2AFD-F95E-8BAA17066A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9556" y="5362493"/>
                <a:ext cx="104041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Western Japan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98" name="Line 96">
                <a:extLst>
                  <a:ext uri="{FF2B5EF4-FFF2-40B4-BE49-F238E27FC236}">
                    <a16:creationId xmlns:a16="http://schemas.microsoft.com/office/drawing/2014/main" id="{62FEF146-77EC-C33B-816D-A1B2C7C384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95103" y="1237171"/>
                <a:ext cx="0" cy="3473499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9" name="Line 97">
                <a:extLst>
                  <a:ext uri="{FF2B5EF4-FFF2-40B4-BE49-F238E27FC236}">
                    <a16:creationId xmlns:a16="http://schemas.microsoft.com/office/drawing/2014/main" id="{060AFF9B-EFD0-4104-3A8A-49A1AE5ECF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07306" y="4710668"/>
                <a:ext cx="8779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0" name="Line 98">
                <a:extLst>
                  <a:ext uri="{FF2B5EF4-FFF2-40B4-BE49-F238E27FC236}">
                    <a16:creationId xmlns:a16="http://schemas.microsoft.com/office/drawing/2014/main" id="{4CA25C03-E44D-5DF3-CE8D-9BAEC64A67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07306" y="3832879"/>
                <a:ext cx="8779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1" name="Line 99">
                <a:extLst>
                  <a:ext uri="{FF2B5EF4-FFF2-40B4-BE49-F238E27FC236}">
                    <a16:creationId xmlns:a16="http://schemas.microsoft.com/office/drawing/2014/main" id="{F211A019-28B0-AF88-1877-F404F92D65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07306" y="2966676"/>
                <a:ext cx="8779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2" name="Line 100">
                <a:extLst>
                  <a:ext uri="{FF2B5EF4-FFF2-40B4-BE49-F238E27FC236}">
                    <a16:creationId xmlns:a16="http://schemas.microsoft.com/office/drawing/2014/main" id="{A85E64C6-1AAE-5403-FA14-FC4DC7F215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07306" y="2103372"/>
                <a:ext cx="8779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3" name="Line 101">
                <a:extLst>
                  <a:ext uri="{FF2B5EF4-FFF2-40B4-BE49-F238E27FC236}">
                    <a16:creationId xmlns:a16="http://schemas.microsoft.com/office/drawing/2014/main" id="{8B25BDC7-66F3-3841-ABEA-250E0B0263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307306" y="1237171"/>
                <a:ext cx="8779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" name="Rectangle 102">
                <a:extLst>
                  <a:ext uri="{FF2B5EF4-FFF2-40B4-BE49-F238E27FC236}">
                    <a16:creationId xmlns:a16="http://schemas.microsoft.com/office/drawing/2014/main" id="{6CBB317B-133D-C9F1-9570-51544B71FD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8600" y="4635346"/>
                <a:ext cx="224421" cy="2154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0.1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5" name="Rectangle 103">
                <a:extLst>
                  <a:ext uri="{FF2B5EF4-FFF2-40B4-BE49-F238E27FC236}">
                    <a16:creationId xmlns:a16="http://schemas.microsoft.com/office/drawing/2014/main" id="{3FAF5760-41CA-C131-F1DF-3F92A8E6BE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8600" y="3769145"/>
                <a:ext cx="224421" cy="2154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0.2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6" name="Rectangle 104">
                <a:extLst>
                  <a:ext uri="{FF2B5EF4-FFF2-40B4-BE49-F238E27FC236}">
                    <a16:creationId xmlns:a16="http://schemas.microsoft.com/office/drawing/2014/main" id="{20CD2D5C-8048-9F89-38AC-A7959E4C9C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8600" y="2902942"/>
                <a:ext cx="224421" cy="2154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0.3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7" name="Rectangle 105">
                <a:extLst>
                  <a:ext uri="{FF2B5EF4-FFF2-40B4-BE49-F238E27FC236}">
                    <a16:creationId xmlns:a16="http://schemas.microsoft.com/office/drawing/2014/main" id="{BE16FF22-36EB-A472-E315-9007589B4B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8600" y="2036742"/>
                <a:ext cx="224421" cy="2154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0.4</a:t>
                </a:r>
                <a:endParaRPr kumimoji="0" lang="ja-JP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8" name="Rectangle 106">
                <a:extLst>
                  <a:ext uri="{FF2B5EF4-FFF2-40B4-BE49-F238E27FC236}">
                    <a16:creationId xmlns:a16="http://schemas.microsoft.com/office/drawing/2014/main" id="{9DF6D427-37B4-9EFC-0C56-3C1029905D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98600" y="1170539"/>
                <a:ext cx="256480" cy="2462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0.5</a:t>
                </a:r>
                <a:endPara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9" name="Rectangle 107">
                <a:extLst>
                  <a:ext uri="{FF2B5EF4-FFF2-40B4-BE49-F238E27FC236}">
                    <a16:creationId xmlns:a16="http://schemas.microsoft.com/office/drawing/2014/main" id="{42229452-997D-C768-9884-A8EF4F4DC5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9818" y="5724616"/>
                <a:ext cx="593110" cy="2462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Region</a:t>
                </a:r>
                <a:endParaRPr kumimoji="0" lang="ja-JP" altLang="ja-JP" sz="16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10" name="Rectangle 108">
                <a:extLst>
                  <a:ext uri="{FF2B5EF4-FFF2-40B4-BE49-F238E27FC236}">
                    <a16:creationId xmlns:a16="http://schemas.microsoft.com/office/drawing/2014/main" id="{B97AA7FF-428F-3A4A-238D-DA95ABF3F7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494294" y="2705458"/>
                <a:ext cx="2086453" cy="2833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6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Crude incidence rates</a:t>
                </a:r>
                <a:endParaRPr kumimoji="0" lang="ja-JP" altLang="ja-JP" sz="5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11" name="Rectangle 109">
                <a:extLst>
                  <a:ext uri="{FF2B5EF4-FFF2-40B4-BE49-F238E27FC236}">
                    <a16:creationId xmlns:a16="http://schemas.microsoft.com/office/drawing/2014/main" id="{61D2D6BA-C9EE-9E83-871A-71F3C2A5EB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95103" y="547686"/>
                <a:ext cx="5391897" cy="4626503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FEB0F462-D339-6E18-7D76-F3C3C46190F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95174" y="1378910"/>
              <a:ext cx="6029" cy="2227762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DF2A0285-9ECE-8C57-48A5-1512BA398375}"/>
                </a:ext>
              </a:extLst>
            </p:cNvPr>
            <p:cNvCxnSpPr>
              <a:cxnSpLocks/>
            </p:cNvCxnSpPr>
            <p:nvPr/>
          </p:nvCxnSpPr>
          <p:spPr>
            <a:xfrm>
              <a:off x="3701202" y="1378910"/>
              <a:ext cx="2165039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6A162669-9762-C63F-15E2-380E9AA07A3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67166" y="1574296"/>
              <a:ext cx="2198151" cy="13891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E923B0C6-C2FA-80BF-FC0D-D97D5346D09F}"/>
                </a:ext>
              </a:extLst>
            </p:cNvPr>
            <p:cNvCxnSpPr>
              <a:cxnSpLocks/>
            </p:cNvCxnSpPr>
            <p:nvPr/>
          </p:nvCxnSpPr>
          <p:spPr>
            <a:xfrm>
              <a:off x="4780845" y="1588190"/>
              <a:ext cx="0" cy="319801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93C03378-17E3-D5DC-C73F-05FE80080E5C}"/>
                </a:ext>
              </a:extLst>
            </p:cNvPr>
            <p:cNvCxnSpPr>
              <a:cxnSpLocks/>
            </p:cNvCxnSpPr>
            <p:nvPr/>
          </p:nvCxnSpPr>
          <p:spPr>
            <a:xfrm>
              <a:off x="5860465" y="1378909"/>
              <a:ext cx="0" cy="181596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20F793E0-E752-016D-544B-811E86142426}"/>
                </a:ext>
              </a:extLst>
            </p:cNvPr>
            <p:cNvCxnSpPr>
              <a:cxnSpLocks/>
            </p:cNvCxnSpPr>
            <p:nvPr/>
          </p:nvCxnSpPr>
          <p:spPr>
            <a:xfrm>
              <a:off x="6965318" y="1588190"/>
              <a:ext cx="0" cy="312145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タイトル 1">
              <a:extLst>
                <a:ext uri="{FF2B5EF4-FFF2-40B4-BE49-F238E27FC236}">
                  <a16:creationId xmlns:a16="http://schemas.microsoft.com/office/drawing/2014/main" id="{6149F546-5731-F6D1-0213-0DF18A367F2C}"/>
                </a:ext>
              </a:extLst>
            </p:cNvPr>
            <p:cNvSpPr txBox="1">
              <a:spLocks/>
            </p:cNvSpPr>
            <p:nvPr/>
          </p:nvSpPr>
          <p:spPr>
            <a:xfrm>
              <a:off x="4495642" y="864343"/>
              <a:ext cx="1077816" cy="530514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rmAutofit/>
            </a:bodyPr>
            <a:lstStyle>
              <a:lvl1pPr algn="l" defTabSz="9144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kumimoji="1"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altLang="ja-JP" sz="1800" i="1" dirty="0">
                  <a:solidFill>
                    <a:schemeClr val="tx1">
                      <a:lumMod val="65000"/>
                      <a:lumOff val="35000"/>
                    </a:schemeClr>
                  </a:solidFill>
                  <a:cs typeface="Times New Roman" panose="02020603050405020304" pitchFamily="18" charset="0"/>
                </a:rPr>
                <a:t>p&lt;</a:t>
              </a:r>
              <a:r>
                <a:rPr lang="en-US" altLang="ja-JP" sz="1800" dirty="0">
                  <a:solidFill>
                    <a:schemeClr val="tx1">
                      <a:lumMod val="65000"/>
                      <a:lumOff val="35000"/>
                    </a:schemeClr>
                  </a:solidFill>
                  <a:cs typeface="Times New Roman" panose="02020603050405020304" pitchFamily="18" charset="0"/>
                </a:rPr>
                <a:t>0.05</a:t>
              </a:r>
              <a:endParaRPr lang="ja-JP" altLang="en-US" sz="1800" dirty="0">
                <a:solidFill>
                  <a:schemeClr val="tx1">
                    <a:lumMod val="65000"/>
                    <a:lumOff val="35000"/>
                  </a:schemeClr>
                </a:solidFill>
                <a:cs typeface="Times New Roman" panose="02020603050405020304" pitchFamily="18" charset="0"/>
              </a:endParaRPr>
            </a:p>
          </p:txBody>
        </p:sp>
      </p:grp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F7C5241E-7535-43C1-B27F-9E229EB3BD3B}"/>
              </a:ext>
            </a:extLst>
          </p:cNvPr>
          <p:cNvSpPr txBox="1"/>
          <p:nvPr/>
        </p:nvSpPr>
        <p:spPr>
          <a:xfrm>
            <a:off x="150021" y="6277102"/>
            <a:ext cx="11891959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dirty="0"/>
              <a:t>Northern Japan showed </a:t>
            </a:r>
            <a:r>
              <a:rPr lang="en-US" altLang="ja-JP" sz="1600" dirty="0"/>
              <a:t>a </a:t>
            </a:r>
            <a:r>
              <a:rPr lang="ja-JP" altLang="en-US" sz="1600" dirty="0"/>
              <a:t>significantly lower crude incidence rate than other regions (vs. Eastern, p=0.035; vs. Southern, p =0.013; and vs. Western, p =0.007 [bonferroni-adjusted Mann-Whitney U test])</a:t>
            </a:r>
          </a:p>
        </p:txBody>
      </p:sp>
    </p:spTree>
    <p:extLst>
      <p:ext uri="{BB962C8B-B14F-4D97-AF65-F5344CB8AC3E}">
        <p14:creationId xmlns:p14="http://schemas.microsoft.com/office/powerpoint/2010/main" val="1552851210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K２">
      <a:majorFont>
        <a:latin typeface="Times New Roman"/>
        <a:ea typeface="メイリオ"/>
        <a:cs typeface=""/>
      </a:majorFont>
      <a:minorFont>
        <a:latin typeface="Times New Roman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6</TotalTime>
  <Words>559</Words>
  <Application>Microsoft Office PowerPoint</Application>
  <PresentationFormat>ワイド画面</PresentationFormat>
  <Paragraphs>80</Paragraphs>
  <Slides>4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明朝</vt:lpstr>
      <vt:lpstr>Arial</vt:lpstr>
      <vt:lpstr>Times New Roman</vt:lpstr>
      <vt:lpstr>1_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萩谷 英大</dc:creator>
  <cp:lastModifiedBy>英将 赤澤</cp:lastModifiedBy>
  <cp:revision>17</cp:revision>
  <dcterms:created xsi:type="dcterms:W3CDTF">2023-07-02T07:41:57Z</dcterms:created>
  <dcterms:modified xsi:type="dcterms:W3CDTF">2023-10-09T01:20:30Z</dcterms:modified>
</cp:coreProperties>
</file>